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38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362;&#26524;&#20113;\&#25968;&#25454;&#20998;&#26512;&#19994;&#21153;&#37096;\02A_&#25968;&#25454;&#20998;&#26512;&#39033;&#30446;\01_&#25968;&#25454;&#20998;&#26512;&#39033;&#30446;\&#23435;&#32418;&#20113;_&#27993;&#27743;&#22823;&#23398;&#31532;&#20108;&#38468;&#23646;&#21307;&#38498;\M240807A001_&#23435;&#32418;&#20113;_&#21069;&#20132;&#21449;&#38887;&#24102;&#25439;&#20260;0807\M240807A001_&#23435;&#32418;&#20113;_&#21069;&#20132;&#21449;&#38887;&#24102;&#25439;&#20260;0807\04_&#32467;&#26524;&#20132;&#20184;&#25991;&#20214;\240829_&#23376;&#39033;&#30446;3_&#37324;&#31243;&#30865;3_&#20132;&#20184;&#32467;&#26524;\&#20132;&#20184;&#32467;&#26524;\&#34987;&#35797;&#26102;&#38388;&#24207;&#21015;_&#21407;&#22987;&#25968;&#2545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362;&#26524;&#20113;\&#25968;&#25454;&#20998;&#26512;&#19994;&#21153;&#37096;\02A_&#25968;&#25454;&#20998;&#26512;&#39033;&#30446;\01_&#25968;&#25454;&#20998;&#26512;&#39033;&#30446;\&#23435;&#32418;&#20113;_&#27993;&#27743;&#22823;&#23398;&#31532;&#20108;&#38468;&#23646;&#21307;&#38498;\M240807A001_&#23435;&#32418;&#20113;_&#21069;&#20132;&#21449;&#38887;&#24102;&#25439;&#20260;0807\M240807A001_&#23435;&#32418;&#20113;_&#21069;&#20132;&#21449;&#38887;&#24102;&#25439;&#20260;0807\04_&#32467;&#26524;&#20132;&#20184;&#25991;&#20214;\240829_&#23376;&#39033;&#30446;3_&#37324;&#31243;&#30865;3_&#20132;&#20184;&#32467;&#26524;\&#20132;&#20184;&#32467;&#26524;\&#34987;&#35797;&#26102;&#38388;&#24207;&#21015;_&#21407;&#22987;&#25968;&#25454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362;&#26524;&#20113;\&#25968;&#25454;&#20998;&#26512;&#19994;&#21153;&#37096;\02A_&#25968;&#25454;&#20998;&#26512;&#39033;&#30446;\01_&#25968;&#25454;&#20998;&#26512;&#39033;&#30446;\&#23435;&#32418;&#20113;_&#27993;&#27743;&#22823;&#23398;&#31532;&#20108;&#38468;&#23646;&#21307;&#38498;\M240807A001_&#23435;&#32418;&#20113;_&#21069;&#20132;&#21449;&#38887;&#24102;&#25439;&#20260;0807\M240807A001_&#23435;&#32418;&#20113;_&#21069;&#20132;&#21449;&#38887;&#24102;&#25439;&#20260;0807\04_&#32467;&#26524;&#20132;&#20184;&#25991;&#20214;\240829_&#23376;&#39033;&#30446;3_&#37324;&#31243;&#30865;3_&#20132;&#20184;&#32467;&#26524;\&#20132;&#20184;&#32467;&#26524;\&#34987;&#35797;&#26102;&#38388;&#24207;&#21015;_&#21407;&#22987;&#25968;&#25454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OLD</a:t>
            </a:r>
            <a:r>
              <a:rPr lang="en-US" b="1" baseline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b="1" baseline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me series plot of raw data for a subject in cp group </a:t>
            </a:r>
            <a:endParaRPr lang="en-US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Sheet1!$A$1</c:f>
              <c:strCache>
                <c:ptCount val="1"/>
                <c:pt idx="0">
                  <c:v>cp_sub_001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yVal>
            <c:numRef>
              <c:f>Sheet1!$A$2:$A$361</c:f>
              <c:numCache>
                <c:formatCode>0_ </c:formatCode>
                <c:ptCount val="360"/>
                <c:pt idx="0">
                  <c:v>7442</c:v>
                </c:pt>
                <c:pt idx="1">
                  <c:v>7508</c:v>
                </c:pt>
                <c:pt idx="2">
                  <c:v>7661</c:v>
                </c:pt>
                <c:pt idx="3">
                  <c:v>7623</c:v>
                </c:pt>
                <c:pt idx="4">
                  <c:v>7316</c:v>
                </c:pt>
                <c:pt idx="5">
                  <c:v>7594</c:v>
                </c:pt>
                <c:pt idx="6">
                  <c:v>7438</c:v>
                </c:pt>
                <c:pt idx="7">
                  <c:v>7555</c:v>
                </c:pt>
                <c:pt idx="8">
                  <c:v>7465</c:v>
                </c:pt>
                <c:pt idx="9">
                  <c:v>7387</c:v>
                </c:pt>
                <c:pt idx="10">
                  <c:v>7451</c:v>
                </c:pt>
                <c:pt idx="11">
                  <c:v>7565</c:v>
                </c:pt>
                <c:pt idx="12">
                  <c:v>7542</c:v>
                </c:pt>
                <c:pt idx="13">
                  <c:v>7546</c:v>
                </c:pt>
                <c:pt idx="14">
                  <c:v>7678</c:v>
                </c:pt>
                <c:pt idx="15">
                  <c:v>7335</c:v>
                </c:pt>
                <c:pt idx="16">
                  <c:v>7138</c:v>
                </c:pt>
                <c:pt idx="17">
                  <c:v>7343</c:v>
                </c:pt>
                <c:pt idx="18">
                  <c:v>7187</c:v>
                </c:pt>
                <c:pt idx="19">
                  <c:v>7458</c:v>
                </c:pt>
                <c:pt idx="20">
                  <c:v>7480</c:v>
                </c:pt>
                <c:pt idx="21">
                  <c:v>7567</c:v>
                </c:pt>
                <c:pt idx="22">
                  <c:v>7904</c:v>
                </c:pt>
                <c:pt idx="23">
                  <c:v>7252</c:v>
                </c:pt>
                <c:pt idx="24">
                  <c:v>7514</c:v>
                </c:pt>
                <c:pt idx="25">
                  <c:v>7748</c:v>
                </c:pt>
                <c:pt idx="26">
                  <c:v>7169</c:v>
                </c:pt>
                <c:pt idx="27">
                  <c:v>7573</c:v>
                </c:pt>
                <c:pt idx="28">
                  <c:v>7297</c:v>
                </c:pt>
                <c:pt idx="29">
                  <c:v>7383</c:v>
                </c:pt>
                <c:pt idx="30">
                  <c:v>7559</c:v>
                </c:pt>
                <c:pt idx="31">
                  <c:v>7654</c:v>
                </c:pt>
                <c:pt idx="32">
                  <c:v>7415</c:v>
                </c:pt>
                <c:pt idx="33">
                  <c:v>7630</c:v>
                </c:pt>
                <c:pt idx="34">
                  <c:v>7636</c:v>
                </c:pt>
                <c:pt idx="35">
                  <c:v>7657</c:v>
                </c:pt>
                <c:pt idx="36">
                  <c:v>7573</c:v>
                </c:pt>
                <c:pt idx="37">
                  <c:v>7554</c:v>
                </c:pt>
                <c:pt idx="38">
                  <c:v>7305</c:v>
                </c:pt>
                <c:pt idx="39">
                  <c:v>7257</c:v>
                </c:pt>
                <c:pt idx="40">
                  <c:v>7392</c:v>
                </c:pt>
                <c:pt idx="41">
                  <c:v>7391</c:v>
                </c:pt>
                <c:pt idx="42">
                  <c:v>7569</c:v>
                </c:pt>
                <c:pt idx="43">
                  <c:v>7475</c:v>
                </c:pt>
                <c:pt idx="44">
                  <c:v>7399</c:v>
                </c:pt>
                <c:pt idx="45">
                  <c:v>7509</c:v>
                </c:pt>
                <c:pt idx="46">
                  <c:v>7555</c:v>
                </c:pt>
                <c:pt idx="47">
                  <c:v>7383</c:v>
                </c:pt>
                <c:pt idx="48">
                  <c:v>7390</c:v>
                </c:pt>
                <c:pt idx="49">
                  <c:v>7584</c:v>
                </c:pt>
                <c:pt idx="50">
                  <c:v>7240</c:v>
                </c:pt>
                <c:pt idx="51">
                  <c:v>7582</c:v>
                </c:pt>
                <c:pt idx="52">
                  <c:v>7501</c:v>
                </c:pt>
                <c:pt idx="53">
                  <c:v>7332</c:v>
                </c:pt>
                <c:pt idx="54">
                  <c:v>7760</c:v>
                </c:pt>
                <c:pt idx="55">
                  <c:v>7549</c:v>
                </c:pt>
                <c:pt idx="56">
                  <c:v>7423</c:v>
                </c:pt>
                <c:pt idx="57">
                  <c:v>7119</c:v>
                </c:pt>
                <c:pt idx="58">
                  <c:v>7518</c:v>
                </c:pt>
                <c:pt idx="59">
                  <c:v>7444</c:v>
                </c:pt>
                <c:pt idx="60">
                  <c:v>7244</c:v>
                </c:pt>
                <c:pt idx="61">
                  <c:v>7409</c:v>
                </c:pt>
                <c:pt idx="62">
                  <c:v>7467</c:v>
                </c:pt>
                <c:pt idx="63">
                  <c:v>7709</c:v>
                </c:pt>
                <c:pt idx="64">
                  <c:v>7510</c:v>
                </c:pt>
                <c:pt idx="65">
                  <c:v>7487</c:v>
                </c:pt>
                <c:pt idx="66">
                  <c:v>7397</c:v>
                </c:pt>
                <c:pt idx="67">
                  <c:v>7075</c:v>
                </c:pt>
                <c:pt idx="68">
                  <c:v>7218</c:v>
                </c:pt>
                <c:pt idx="69">
                  <c:v>7350</c:v>
                </c:pt>
                <c:pt idx="70">
                  <c:v>7529</c:v>
                </c:pt>
                <c:pt idx="71">
                  <c:v>7483</c:v>
                </c:pt>
                <c:pt idx="72">
                  <c:v>7721</c:v>
                </c:pt>
                <c:pt idx="73">
                  <c:v>7697</c:v>
                </c:pt>
                <c:pt idx="74">
                  <c:v>7616</c:v>
                </c:pt>
                <c:pt idx="75">
                  <c:v>7276</c:v>
                </c:pt>
                <c:pt idx="76">
                  <c:v>7475</c:v>
                </c:pt>
                <c:pt idx="77">
                  <c:v>7255</c:v>
                </c:pt>
                <c:pt idx="78">
                  <c:v>7287</c:v>
                </c:pt>
                <c:pt idx="79">
                  <c:v>7560</c:v>
                </c:pt>
                <c:pt idx="80">
                  <c:v>7612</c:v>
                </c:pt>
                <c:pt idx="81">
                  <c:v>7684</c:v>
                </c:pt>
                <c:pt idx="82">
                  <c:v>7579</c:v>
                </c:pt>
                <c:pt idx="83">
                  <c:v>7672</c:v>
                </c:pt>
                <c:pt idx="84">
                  <c:v>7344</c:v>
                </c:pt>
                <c:pt idx="85">
                  <c:v>7591</c:v>
                </c:pt>
                <c:pt idx="86">
                  <c:v>7456</c:v>
                </c:pt>
                <c:pt idx="87">
                  <c:v>7302</c:v>
                </c:pt>
                <c:pt idx="88">
                  <c:v>7689</c:v>
                </c:pt>
                <c:pt idx="89">
                  <c:v>7630</c:v>
                </c:pt>
                <c:pt idx="90">
                  <c:v>7616</c:v>
                </c:pt>
                <c:pt idx="91">
                  <c:v>7608</c:v>
                </c:pt>
                <c:pt idx="92">
                  <c:v>7805</c:v>
                </c:pt>
                <c:pt idx="93">
                  <c:v>7165</c:v>
                </c:pt>
                <c:pt idx="94">
                  <c:v>7452</c:v>
                </c:pt>
                <c:pt idx="95">
                  <c:v>7415</c:v>
                </c:pt>
                <c:pt idx="96">
                  <c:v>7541</c:v>
                </c:pt>
                <c:pt idx="97">
                  <c:v>7646</c:v>
                </c:pt>
                <c:pt idx="98">
                  <c:v>7466</c:v>
                </c:pt>
                <c:pt idx="99">
                  <c:v>7666</c:v>
                </c:pt>
                <c:pt idx="100">
                  <c:v>7239</c:v>
                </c:pt>
                <c:pt idx="101">
                  <c:v>7459</c:v>
                </c:pt>
                <c:pt idx="102">
                  <c:v>7729</c:v>
                </c:pt>
                <c:pt idx="103">
                  <c:v>7490</c:v>
                </c:pt>
                <c:pt idx="104">
                  <c:v>7562</c:v>
                </c:pt>
                <c:pt idx="105">
                  <c:v>7806</c:v>
                </c:pt>
                <c:pt idx="106">
                  <c:v>7088</c:v>
                </c:pt>
                <c:pt idx="107">
                  <c:v>7442</c:v>
                </c:pt>
                <c:pt idx="108">
                  <c:v>7553</c:v>
                </c:pt>
                <c:pt idx="109">
                  <c:v>7590</c:v>
                </c:pt>
                <c:pt idx="110">
                  <c:v>7737</c:v>
                </c:pt>
                <c:pt idx="111">
                  <c:v>7720</c:v>
                </c:pt>
                <c:pt idx="112">
                  <c:v>7765</c:v>
                </c:pt>
                <c:pt idx="113">
                  <c:v>7718</c:v>
                </c:pt>
                <c:pt idx="114">
                  <c:v>7593</c:v>
                </c:pt>
                <c:pt idx="115">
                  <c:v>7531</c:v>
                </c:pt>
                <c:pt idx="116">
                  <c:v>7635</c:v>
                </c:pt>
                <c:pt idx="117">
                  <c:v>7621</c:v>
                </c:pt>
                <c:pt idx="118">
                  <c:v>7438</c:v>
                </c:pt>
                <c:pt idx="119">
                  <c:v>7798</c:v>
                </c:pt>
                <c:pt idx="120">
                  <c:v>7561</c:v>
                </c:pt>
                <c:pt idx="121">
                  <c:v>7558</c:v>
                </c:pt>
                <c:pt idx="122">
                  <c:v>7641</c:v>
                </c:pt>
                <c:pt idx="123">
                  <c:v>7780</c:v>
                </c:pt>
                <c:pt idx="124">
                  <c:v>7796</c:v>
                </c:pt>
                <c:pt idx="125">
                  <c:v>7657</c:v>
                </c:pt>
                <c:pt idx="126">
                  <c:v>7578</c:v>
                </c:pt>
                <c:pt idx="127">
                  <c:v>7390</c:v>
                </c:pt>
                <c:pt idx="128">
                  <c:v>7705</c:v>
                </c:pt>
                <c:pt idx="129">
                  <c:v>7090</c:v>
                </c:pt>
                <c:pt idx="130">
                  <c:v>7456</c:v>
                </c:pt>
                <c:pt idx="131">
                  <c:v>7647</c:v>
                </c:pt>
                <c:pt idx="132">
                  <c:v>7519</c:v>
                </c:pt>
                <c:pt idx="133">
                  <c:v>7439</c:v>
                </c:pt>
                <c:pt idx="134">
                  <c:v>7624</c:v>
                </c:pt>
                <c:pt idx="135">
                  <c:v>7683</c:v>
                </c:pt>
                <c:pt idx="136">
                  <c:v>7423</c:v>
                </c:pt>
                <c:pt idx="137">
                  <c:v>7358</c:v>
                </c:pt>
                <c:pt idx="138">
                  <c:v>7684</c:v>
                </c:pt>
                <c:pt idx="139">
                  <c:v>7485</c:v>
                </c:pt>
                <c:pt idx="140">
                  <c:v>7656</c:v>
                </c:pt>
                <c:pt idx="141">
                  <c:v>7882</c:v>
                </c:pt>
                <c:pt idx="142">
                  <c:v>7976</c:v>
                </c:pt>
                <c:pt idx="143">
                  <c:v>7869</c:v>
                </c:pt>
                <c:pt idx="144">
                  <c:v>7565</c:v>
                </c:pt>
                <c:pt idx="145">
                  <c:v>7372</c:v>
                </c:pt>
                <c:pt idx="146">
                  <c:v>7374</c:v>
                </c:pt>
                <c:pt idx="147">
                  <c:v>7243</c:v>
                </c:pt>
                <c:pt idx="148">
                  <c:v>7385</c:v>
                </c:pt>
                <c:pt idx="149">
                  <c:v>7445</c:v>
                </c:pt>
                <c:pt idx="150">
                  <c:v>7432</c:v>
                </c:pt>
                <c:pt idx="151">
                  <c:v>7553</c:v>
                </c:pt>
                <c:pt idx="152">
                  <c:v>7634</c:v>
                </c:pt>
                <c:pt idx="153">
                  <c:v>7742</c:v>
                </c:pt>
                <c:pt idx="154">
                  <c:v>7618</c:v>
                </c:pt>
                <c:pt idx="155">
                  <c:v>7570</c:v>
                </c:pt>
                <c:pt idx="156">
                  <c:v>7152</c:v>
                </c:pt>
                <c:pt idx="157">
                  <c:v>7576</c:v>
                </c:pt>
                <c:pt idx="158">
                  <c:v>7880</c:v>
                </c:pt>
                <c:pt idx="159">
                  <c:v>7675</c:v>
                </c:pt>
                <c:pt idx="160">
                  <c:v>7439</c:v>
                </c:pt>
                <c:pt idx="161">
                  <c:v>7591</c:v>
                </c:pt>
                <c:pt idx="162">
                  <c:v>7650</c:v>
                </c:pt>
                <c:pt idx="163">
                  <c:v>7648</c:v>
                </c:pt>
                <c:pt idx="164">
                  <c:v>7510</c:v>
                </c:pt>
                <c:pt idx="165">
                  <c:v>7761</c:v>
                </c:pt>
                <c:pt idx="166">
                  <c:v>7717</c:v>
                </c:pt>
                <c:pt idx="167">
                  <c:v>7534</c:v>
                </c:pt>
                <c:pt idx="168">
                  <c:v>7447</c:v>
                </c:pt>
                <c:pt idx="169">
                  <c:v>7516</c:v>
                </c:pt>
                <c:pt idx="170">
                  <c:v>7606</c:v>
                </c:pt>
                <c:pt idx="171">
                  <c:v>7938</c:v>
                </c:pt>
                <c:pt idx="172">
                  <c:v>7688</c:v>
                </c:pt>
                <c:pt idx="173">
                  <c:v>7879</c:v>
                </c:pt>
                <c:pt idx="174">
                  <c:v>7821</c:v>
                </c:pt>
                <c:pt idx="175">
                  <c:v>8015</c:v>
                </c:pt>
                <c:pt idx="176">
                  <c:v>7661</c:v>
                </c:pt>
                <c:pt idx="177">
                  <c:v>7663</c:v>
                </c:pt>
                <c:pt idx="178">
                  <c:v>7674</c:v>
                </c:pt>
                <c:pt idx="179">
                  <c:v>7459</c:v>
                </c:pt>
                <c:pt idx="180">
                  <c:v>7635</c:v>
                </c:pt>
                <c:pt idx="181">
                  <c:v>7635</c:v>
                </c:pt>
                <c:pt idx="182">
                  <c:v>7813</c:v>
                </c:pt>
                <c:pt idx="183">
                  <c:v>7763</c:v>
                </c:pt>
                <c:pt idx="184">
                  <c:v>7731</c:v>
                </c:pt>
                <c:pt idx="185">
                  <c:v>7743</c:v>
                </c:pt>
                <c:pt idx="186">
                  <c:v>7767</c:v>
                </c:pt>
                <c:pt idx="187">
                  <c:v>7491</c:v>
                </c:pt>
                <c:pt idx="188">
                  <c:v>7608</c:v>
                </c:pt>
                <c:pt idx="189">
                  <c:v>7720</c:v>
                </c:pt>
                <c:pt idx="190">
                  <c:v>7589</c:v>
                </c:pt>
                <c:pt idx="191">
                  <c:v>7795</c:v>
                </c:pt>
                <c:pt idx="192">
                  <c:v>7473</c:v>
                </c:pt>
                <c:pt idx="193">
                  <c:v>8118</c:v>
                </c:pt>
                <c:pt idx="194">
                  <c:v>7754</c:v>
                </c:pt>
                <c:pt idx="195">
                  <c:v>7590</c:v>
                </c:pt>
                <c:pt idx="196">
                  <c:v>7563</c:v>
                </c:pt>
                <c:pt idx="197">
                  <c:v>7655</c:v>
                </c:pt>
                <c:pt idx="198">
                  <c:v>7636</c:v>
                </c:pt>
                <c:pt idx="199">
                  <c:v>7436</c:v>
                </c:pt>
                <c:pt idx="200">
                  <c:v>7951</c:v>
                </c:pt>
                <c:pt idx="201">
                  <c:v>7826</c:v>
                </c:pt>
                <c:pt idx="202">
                  <c:v>7975</c:v>
                </c:pt>
                <c:pt idx="203">
                  <c:v>7388</c:v>
                </c:pt>
                <c:pt idx="204">
                  <c:v>7543</c:v>
                </c:pt>
                <c:pt idx="205">
                  <c:v>7188</c:v>
                </c:pt>
                <c:pt idx="206">
                  <c:v>7675</c:v>
                </c:pt>
                <c:pt idx="207">
                  <c:v>7413</c:v>
                </c:pt>
                <c:pt idx="208">
                  <c:v>7168</c:v>
                </c:pt>
                <c:pt idx="209">
                  <c:v>7871</c:v>
                </c:pt>
                <c:pt idx="210">
                  <c:v>8044</c:v>
                </c:pt>
                <c:pt idx="211">
                  <c:v>7559</c:v>
                </c:pt>
                <c:pt idx="212">
                  <c:v>7883</c:v>
                </c:pt>
                <c:pt idx="213">
                  <c:v>7659</c:v>
                </c:pt>
                <c:pt idx="214">
                  <c:v>7623</c:v>
                </c:pt>
                <c:pt idx="215">
                  <c:v>7723</c:v>
                </c:pt>
                <c:pt idx="216">
                  <c:v>7305</c:v>
                </c:pt>
                <c:pt idx="217">
                  <c:v>7657</c:v>
                </c:pt>
                <c:pt idx="218">
                  <c:v>7734</c:v>
                </c:pt>
                <c:pt idx="219">
                  <c:v>7595</c:v>
                </c:pt>
                <c:pt idx="220">
                  <c:v>8108</c:v>
                </c:pt>
                <c:pt idx="221">
                  <c:v>7747</c:v>
                </c:pt>
                <c:pt idx="222">
                  <c:v>7468</c:v>
                </c:pt>
                <c:pt idx="223">
                  <c:v>7590</c:v>
                </c:pt>
                <c:pt idx="224">
                  <c:v>7270</c:v>
                </c:pt>
                <c:pt idx="225">
                  <c:v>7806</c:v>
                </c:pt>
                <c:pt idx="226">
                  <c:v>7488</c:v>
                </c:pt>
                <c:pt idx="227">
                  <c:v>7610</c:v>
                </c:pt>
                <c:pt idx="228">
                  <c:v>7860</c:v>
                </c:pt>
                <c:pt idx="229">
                  <c:v>7456</c:v>
                </c:pt>
                <c:pt idx="230">
                  <c:v>7843</c:v>
                </c:pt>
                <c:pt idx="231">
                  <c:v>7606</c:v>
                </c:pt>
                <c:pt idx="232">
                  <c:v>7496</c:v>
                </c:pt>
                <c:pt idx="233">
                  <c:v>7301</c:v>
                </c:pt>
                <c:pt idx="234">
                  <c:v>7662</c:v>
                </c:pt>
                <c:pt idx="235">
                  <c:v>7420</c:v>
                </c:pt>
                <c:pt idx="236">
                  <c:v>7645</c:v>
                </c:pt>
                <c:pt idx="237">
                  <c:v>7843</c:v>
                </c:pt>
                <c:pt idx="238">
                  <c:v>7889</c:v>
                </c:pt>
                <c:pt idx="239">
                  <c:v>7652</c:v>
                </c:pt>
                <c:pt idx="240">
                  <c:v>7937</c:v>
                </c:pt>
                <c:pt idx="241">
                  <c:v>7884</c:v>
                </c:pt>
                <c:pt idx="242">
                  <c:v>7432</c:v>
                </c:pt>
                <c:pt idx="243">
                  <c:v>7529</c:v>
                </c:pt>
                <c:pt idx="244">
                  <c:v>7728</c:v>
                </c:pt>
                <c:pt idx="245">
                  <c:v>7616</c:v>
                </c:pt>
                <c:pt idx="246">
                  <c:v>7743</c:v>
                </c:pt>
                <c:pt idx="247">
                  <c:v>7473</c:v>
                </c:pt>
                <c:pt idx="248">
                  <c:v>7670</c:v>
                </c:pt>
                <c:pt idx="249">
                  <c:v>7785</c:v>
                </c:pt>
                <c:pt idx="250">
                  <c:v>7623</c:v>
                </c:pt>
                <c:pt idx="251">
                  <c:v>8069</c:v>
                </c:pt>
                <c:pt idx="252">
                  <c:v>7840</c:v>
                </c:pt>
                <c:pt idx="253">
                  <c:v>7700</c:v>
                </c:pt>
                <c:pt idx="254">
                  <c:v>7663</c:v>
                </c:pt>
                <c:pt idx="255">
                  <c:v>7376</c:v>
                </c:pt>
                <c:pt idx="256">
                  <c:v>7773</c:v>
                </c:pt>
                <c:pt idx="257">
                  <c:v>7971</c:v>
                </c:pt>
                <c:pt idx="258">
                  <c:v>7412</c:v>
                </c:pt>
                <c:pt idx="259">
                  <c:v>7818</c:v>
                </c:pt>
                <c:pt idx="260">
                  <c:v>7928</c:v>
                </c:pt>
                <c:pt idx="261">
                  <c:v>7740</c:v>
                </c:pt>
                <c:pt idx="262">
                  <c:v>7766</c:v>
                </c:pt>
                <c:pt idx="263">
                  <c:v>7909</c:v>
                </c:pt>
                <c:pt idx="264">
                  <c:v>7674</c:v>
                </c:pt>
                <c:pt idx="265">
                  <c:v>7690</c:v>
                </c:pt>
                <c:pt idx="266">
                  <c:v>7584</c:v>
                </c:pt>
                <c:pt idx="267">
                  <c:v>7563</c:v>
                </c:pt>
                <c:pt idx="268">
                  <c:v>7761</c:v>
                </c:pt>
                <c:pt idx="269">
                  <c:v>7443</c:v>
                </c:pt>
                <c:pt idx="270">
                  <c:v>7689</c:v>
                </c:pt>
                <c:pt idx="271">
                  <c:v>7682</c:v>
                </c:pt>
                <c:pt idx="272">
                  <c:v>7648</c:v>
                </c:pt>
                <c:pt idx="273">
                  <c:v>7423</c:v>
                </c:pt>
                <c:pt idx="274">
                  <c:v>7559</c:v>
                </c:pt>
                <c:pt idx="275">
                  <c:v>7647</c:v>
                </c:pt>
                <c:pt idx="276">
                  <c:v>7953</c:v>
                </c:pt>
                <c:pt idx="277">
                  <c:v>7647</c:v>
                </c:pt>
                <c:pt idx="278">
                  <c:v>7856</c:v>
                </c:pt>
                <c:pt idx="279">
                  <c:v>7551</c:v>
                </c:pt>
                <c:pt idx="280">
                  <c:v>7694</c:v>
                </c:pt>
                <c:pt idx="281">
                  <c:v>7356</c:v>
                </c:pt>
                <c:pt idx="282">
                  <c:v>7635</c:v>
                </c:pt>
                <c:pt idx="283">
                  <c:v>7611</c:v>
                </c:pt>
                <c:pt idx="284">
                  <c:v>7843</c:v>
                </c:pt>
                <c:pt idx="285">
                  <c:v>7926</c:v>
                </c:pt>
                <c:pt idx="286">
                  <c:v>7560</c:v>
                </c:pt>
                <c:pt idx="287">
                  <c:v>7463</c:v>
                </c:pt>
                <c:pt idx="288">
                  <c:v>7698</c:v>
                </c:pt>
                <c:pt idx="289">
                  <c:v>7659</c:v>
                </c:pt>
                <c:pt idx="290">
                  <c:v>7786</c:v>
                </c:pt>
                <c:pt idx="291">
                  <c:v>7607</c:v>
                </c:pt>
                <c:pt idx="292">
                  <c:v>7849</c:v>
                </c:pt>
                <c:pt idx="293">
                  <c:v>7681</c:v>
                </c:pt>
                <c:pt idx="294">
                  <c:v>7576</c:v>
                </c:pt>
                <c:pt idx="295">
                  <c:v>7514</c:v>
                </c:pt>
                <c:pt idx="296">
                  <c:v>7644</c:v>
                </c:pt>
                <c:pt idx="297">
                  <c:v>7668</c:v>
                </c:pt>
                <c:pt idx="298">
                  <c:v>7668</c:v>
                </c:pt>
                <c:pt idx="299">
                  <c:v>7731</c:v>
                </c:pt>
                <c:pt idx="300">
                  <c:v>7677</c:v>
                </c:pt>
                <c:pt idx="301">
                  <c:v>7631</c:v>
                </c:pt>
                <c:pt idx="302">
                  <c:v>7798</c:v>
                </c:pt>
                <c:pt idx="303">
                  <c:v>7806</c:v>
                </c:pt>
                <c:pt idx="304">
                  <c:v>7897</c:v>
                </c:pt>
                <c:pt idx="305">
                  <c:v>7756</c:v>
                </c:pt>
                <c:pt idx="306">
                  <c:v>7475</c:v>
                </c:pt>
                <c:pt idx="307">
                  <c:v>7754</c:v>
                </c:pt>
                <c:pt idx="308">
                  <c:v>7671</c:v>
                </c:pt>
                <c:pt idx="309">
                  <c:v>7859</c:v>
                </c:pt>
                <c:pt idx="310">
                  <c:v>7703</c:v>
                </c:pt>
                <c:pt idx="311">
                  <c:v>7705</c:v>
                </c:pt>
                <c:pt idx="312">
                  <c:v>7824</c:v>
                </c:pt>
                <c:pt idx="313">
                  <c:v>7865</c:v>
                </c:pt>
                <c:pt idx="314">
                  <c:v>7448</c:v>
                </c:pt>
                <c:pt idx="315">
                  <c:v>7468</c:v>
                </c:pt>
                <c:pt idx="316">
                  <c:v>7594</c:v>
                </c:pt>
                <c:pt idx="317">
                  <c:v>7670</c:v>
                </c:pt>
                <c:pt idx="318">
                  <c:v>7683</c:v>
                </c:pt>
                <c:pt idx="319">
                  <c:v>7349</c:v>
                </c:pt>
                <c:pt idx="320">
                  <c:v>7654</c:v>
                </c:pt>
                <c:pt idx="321">
                  <c:v>7726</c:v>
                </c:pt>
                <c:pt idx="322">
                  <c:v>7937</c:v>
                </c:pt>
                <c:pt idx="323">
                  <c:v>7798</c:v>
                </c:pt>
                <c:pt idx="324">
                  <c:v>7461</c:v>
                </c:pt>
                <c:pt idx="325">
                  <c:v>7500</c:v>
                </c:pt>
                <c:pt idx="326">
                  <c:v>7583</c:v>
                </c:pt>
                <c:pt idx="327">
                  <c:v>7820</c:v>
                </c:pt>
                <c:pt idx="328">
                  <c:v>7524</c:v>
                </c:pt>
                <c:pt idx="329">
                  <c:v>7772</c:v>
                </c:pt>
                <c:pt idx="330">
                  <c:v>7598</c:v>
                </c:pt>
                <c:pt idx="331">
                  <c:v>7791</c:v>
                </c:pt>
                <c:pt idx="332">
                  <c:v>7365</c:v>
                </c:pt>
                <c:pt idx="333">
                  <c:v>7553</c:v>
                </c:pt>
                <c:pt idx="334">
                  <c:v>7788</c:v>
                </c:pt>
                <c:pt idx="335">
                  <c:v>7871</c:v>
                </c:pt>
                <c:pt idx="336">
                  <c:v>7782</c:v>
                </c:pt>
                <c:pt idx="337">
                  <c:v>7622</c:v>
                </c:pt>
                <c:pt idx="338">
                  <c:v>7740</c:v>
                </c:pt>
                <c:pt idx="339">
                  <c:v>7734</c:v>
                </c:pt>
                <c:pt idx="340">
                  <c:v>7548</c:v>
                </c:pt>
                <c:pt idx="341">
                  <c:v>7483</c:v>
                </c:pt>
                <c:pt idx="342">
                  <c:v>7597</c:v>
                </c:pt>
                <c:pt idx="343">
                  <c:v>7547</c:v>
                </c:pt>
                <c:pt idx="344">
                  <c:v>7536</c:v>
                </c:pt>
                <c:pt idx="345">
                  <c:v>7865</c:v>
                </c:pt>
                <c:pt idx="346">
                  <c:v>7707</c:v>
                </c:pt>
                <c:pt idx="347">
                  <c:v>7474</c:v>
                </c:pt>
                <c:pt idx="348">
                  <c:v>7314</c:v>
                </c:pt>
                <c:pt idx="349">
                  <c:v>7879</c:v>
                </c:pt>
                <c:pt idx="350">
                  <c:v>7828</c:v>
                </c:pt>
                <c:pt idx="351">
                  <c:v>7464</c:v>
                </c:pt>
                <c:pt idx="352">
                  <c:v>7463</c:v>
                </c:pt>
                <c:pt idx="353">
                  <c:v>7638</c:v>
                </c:pt>
                <c:pt idx="354">
                  <c:v>7661</c:v>
                </c:pt>
                <c:pt idx="355">
                  <c:v>7576</c:v>
                </c:pt>
                <c:pt idx="356">
                  <c:v>7640</c:v>
                </c:pt>
                <c:pt idx="357">
                  <c:v>7463</c:v>
                </c:pt>
                <c:pt idx="358">
                  <c:v>7615</c:v>
                </c:pt>
                <c:pt idx="359">
                  <c:v>762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DBC-4946-B36D-10E6165DCA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14086944"/>
        <c:axId val="514086584"/>
      </c:scatterChart>
      <c:valAx>
        <c:axId val="514086944"/>
        <c:scaling>
          <c:orientation val="minMax"/>
          <c:max val="4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1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point</a:t>
                </a:r>
                <a:endParaRPr lang="zh-CN" sz="11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14086584"/>
        <c:crosses val="autoZero"/>
        <c:crossBetween val="midCat"/>
      </c:valAx>
      <c:valAx>
        <c:axId val="5140865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1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ime series value</a:t>
                </a:r>
                <a:endParaRPr lang="zh-CN" altLang="en-US" sz="11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9234971353386077E-2"/>
              <c:y val="0.372391652262979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0_ 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140869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OLD</a:t>
            </a:r>
            <a:r>
              <a:rPr lang="en-US" altLang="zh-CN" b="1" baseline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ime series plot of raw data for a subject in np group </a:t>
            </a:r>
            <a:endParaRPr lang="en-US" altLang="zh-CN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Sheet2!$A$1</c:f>
              <c:strCache>
                <c:ptCount val="1"/>
                <c:pt idx="0">
                  <c:v>np_sub_008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yVal>
            <c:numRef>
              <c:f>Sheet2!$A$2:$A$361</c:f>
              <c:numCache>
                <c:formatCode>0_ </c:formatCode>
                <c:ptCount val="360"/>
                <c:pt idx="0">
                  <c:v>6092</c:v>
                </c:pt>
                <c:pt idx="1">
                  <c:v>5899</c:v>
                </c:pt>
                <c:pt idx="2">
                  <c:v>6131</c:v>
                </c:pt>
                <c:pt idx="3">
                  <c:v>5848</c:v>
                </c:pt>
                <c:pt idx="4">
                  <c:v>5859</c:v>
                </c:pt>
                <c:pt idx="5">
                  <c:v>6041</c:v>
                </c:pt>
                <c:pt idx="6">
                  <c:v>5866</c:v>
                </c:pt>
                <c:pt idx="7">
                  <c:v>5980</c:v>
                </c:pt>
                <c:pt idx="8">
                  <c:v>5803</c:v>
                </c:pt>
                <c:pt idx="9">
                  <c:v>6283</c:v>
                </c:pt>
                <c:pt idx="10">
                  <c:v>6089</c:v>
                </c:pt>
                <c:pt idx="11">
                  <c:v>6126</c:v>
                </c:pt>
                <c:pt idx="12">
                  <c:v>5828</c:v>
                </c:pt>
                <c:pt idx="13">
                  <c:v>5821</c:v>
                </c:pt>
                <c:pt idx="14">
                  <c:v>6120</c:v>
                </c:pt>
                <c:pt idx="15">
                  <c:v>5940</c:v>
                </c:pt>
                <c:pt idx="16">
                  <c:v>6054</c:v>
                </c:pt>
                <c:pt idx="17">
                  <c:v>5921</c:v>
                </c:pt>
                <c:pt idx="18">
                  <c:v>5983</c:v>
                </c:pt>
                <c:pt idx="19">
                  <c:v>6038</c:v>
                </c:pt>
                <c:pt idx="20">
                  <c:v>6212</c:v>
                </c:pt>
                <c:pt idx="21">
                  <c:v>5716</c:v>
                </c:pt>
                <c:pt idx="22">
                  <c:v>6071</c:v>
                </c:pt>
                <c:pt idx="23">
                  <c:v>5944</c:v>
                </c:pt>
                <c:pt idx="24">
                  <c:v>6322</c:v>
                </c:pt>
                <c:pt idx="25">
                  <c:v>6197</c:v>
                </c:pt>
                <c:pt idx="26">
                  <c:v>6207</c:v>
                </c:pt>
                <c:pt idx="27">
                  <c:v>5840</c:v>
                </c:pt>
                <c:pt idx="28">
                  <c:v>6035</c:v>
                </c:pt>
                <c:pt idx="29">
                  <c:v>6201</c:v>
                </c:pt>
                <c:pt idx="30">
                  <c:v>6226</c:v>
                </c:pt>
                <c:pt idx="31">
                  <c:v>5950</c:v>
                </c:pt>
                <c:pt idx="32">
                  <c:v>6194</c:v>
                </c:pt>
                <c:pt idx="33">
                  <c:v>6019</c:v>
                </c:pt>
                <c:pt idx="34">
                  <c:v>6050</c:v>
                </c:pt>
                <c:pt idx="35">
                  <c:v>5967</c:v>
                </c:pt>
                <c:pt idx="36">
                  <c:v>5959</c:v>
                </c:pt>
                <c:pt idx="37">
                  <c:v>5970</c:v>
                </c:pt>
                <c:pt idx="38">
                  <c:v>5897</c:v>
                </c:pt>
                <c:pt idx="39">
                  <c:v>5881</c:v>
                </c:pt>
                <c:pt idx="40">
                  <c:v>5916</c:v>
                </c:pt>
                <c:pt idx="41">
                  <c:v>6101</c:v>
                </c:pt>
                <c:pt idx="42">
                  <c:v>5611</c:v>
                </c:pt>
                <c:pt idx="43">
                  <c:v>5953</c:v>
                </c:pt>
                <c:pt idx="44">
                  <c:v>6043</c:v>
                </c:pt>
                <c:pt idx="45">
                  <c:v>5794</c:v>
                </c:pt>
                <c:pt idx="46">
                  <c:v>5913</c:v>
                </c:pt>
                <c:pt idx="47">
                  <c:v>5869</c:v>
                </c:pt>
                <c:pt idx="48">
                  <c:v>5693</c:v>
                </c:pt>
                <c:pt idx="49">
                  <c:v>5782</c:v>
                </c:pt>
                <c:pt idx="50">
                  <c:v>5926</c:v>
                </c:pt>
                <c:pt idx="51">
                  <c:v>6005</c:v>
                </c:pt>
                <c:pt idx="52">
                  <c:v>6118</c:v>
                </c:pt>
                <c:pt idx="53">
                  <c:v>5949</c:v>
                </c:pt>
                <c:pt idx="54">
                  <c:v>5991</c:v>
                </c:pt>
                <c:pt idx="55">
                  <c:v>5921</c:v>
                </c:pt>
                <c:pt idx="56">
                  <c:v>6110</c:v>
                </c:pt>
                <c:pt idx="57">
                  <c:v>5927</c:v>
                </c:pt>
                <c:pt idx="58">
                  <c:v>5988</c:v>
                </c:pt>
                <c:pt idx="59">
                  <c:v>6382</c:v>
                </c:pt>
                <c:pt idx="60">
                  <c:v>5951</c:v>
                </c:pt>
                <c:pt idx="61">
                  <c:v>5884</c:v>
                </c:pt>
                <c:pt idx="62">
                  <c:v>5925</c:v>
                </c:pt>
                <c:pt idx="63">
                  <c:v>5973</c:v>
                </c:pt>
                <c:pt idx="64">
                  <c:v>5992</c:v>
                </c:pt>
                <c:pt idx="65">
                  <c:v>6095</c:v>
                </c:pt>
                <c:pt idx="66">
                  <c:v>5934</c:v>
                </c:pt>
                <c:pt idx="67">
                  <c:v>5998</c:v>
                </c:pt>
                <c:pt idx="68">
                  <c:v>5947</c:v>
                </c:pt>
                <c:pt idx="69">
                  <c:v>5746</c:v>
                </c:pt>
                <c:pt idx="70">
                  <c:v>6327</c:v>
                </c:pt>
                <c:pt idx="71">
                  <c:v>5968</c:v>
                </c:pt>
                <c:pt idx="72">
                  <c:v>5873</c:v>
                </c:pt>
                <c:pt idx="73">
                  <c:v>6249</c:v>
                </c:pt>
                <c:pt idx="74">
                  <c:v>5724</c:v>
                </c:pt>
                <c:pt idx="75">
                  <c:v>5942</c:v>
                </c:pt>
                <c:pt idx="76">
                  <c:v>6141</c:v>
                </c:pt>
                <c:pt idx="77">
                  <c:v>6144</c:v>
                </c:pt>
                <c:pt idx="78">
                  <c:v>5907</c:v>
                </c:pt>
                <c:pt idx="79">
                  <c:v>5925</c:v>
                </c:pt>
                <c:pt idx="80">
                  <c:v>6274</c:v>
                </c:pt>
                <c:pt idx="81">
                  <c:v>5920</c:v>
                </c:pt>
                <c:pt idx="82">
                  <c:v>5898</c:v>
                </c:pt>
                <c:pt idx="83">
                  <c:v>6017</c:v>
                </c:pt>
                <c:pt idx="84">
                  <c:v>5715</c:v>
                </c:pt>
                <c:pt idx="85">
                  <c:v>6080</c:v>
                </c:pt>
                <c:pt idx="86">
                  <c:v>6339</c:v>
                </c:pt>
                <c:pt idx="87">
                  <c:v>6147</c:v>
                </c:pt>
                <c:pt idx="88">
                  <c:v>6130</c:v>
                </c:pt>
                <c:pt idx="89">
                  <c:v>6027</c:v>
                </c:pt>
                <c:pt idx="90">
                  <c:v>5825</c:v>
                </c:pt>
                <c:pt idx="91">
                  <c:v>6050</c:v>
                </c:pt>
                <c:pt idx="92">
                  <c:v>6335</c:v>
                </c:pt>
                <c:pt idx="93">
                  <c:v>6125</c:v>
                </c:pt>
                <c:pt idx="94">
                  <c:v>6383</c:v>
                </c:pt>
                <c:pt idx="95">
                  <c:v>5846</c:v>
                </c:pt>
                <c:pt idx="96">
                  <c:v>6012</c:v>
                </c:pt>
                <c:pt idx="97">
                  <c:v>6161</c:v>
                </c:pt>
                <c:pt idx="98">
                  <c:v>6007</c:v>
                </c:pt>
                <c:pt idx="99">
                  <c:v>5812</c:v>
                </c:pt>
                <c:pt idx="100">
                  <c:v>6276</c:v>
                </c:pt>
                <c:pt idx="101">
                  <c:v>6021</c:v>
                </c:pt>
                <c:pt idx="102">
                  <c:v>6244</c:v>
                </c:pt>
                <c:pt idx="103">
                  <c:v>5942</c:v>
                </c:pt>
                <c:pt idx="104">
                  <c:v>6382</c:v>
                </c:pt>
                <c:pt idx="105">
                  <c:v>6067</c:v>
                </c:pt>
                <c:pt idx="106">
                  <c:v>5898</c:v>
                </c:pt>
                <c:pt idx="107">
                  <c:v>5818</c:v>
                </c:pt>
                <c:pt idx="108">
                  <c:v>6057</c:v>
                </c:pt>
                <c:pt idx="109">
                  <c:v>6097</c:v>
                </c:pt>
                <c:pt idx="110">
                  <c:v>6030</c:v>
                </c:pt>
                <c:pt idx="111">
                  <c:v>6197</c:v>
                </c:pt>
                <c:pt idx="112">
                  <c:v>5958</c:v>
                </c:pt>
                <c:pt idx="113">
                  <c:v>5970</c:v>
                </c:pt>
                <c:pt idx="114">
                  <c:v>5938</c:v>
                </c:pt>
                <c:pt idx="115">
                  <c:v>5836</c:v>
                </c:pt>
                <c:pt idx="116">
                  <c:v>5732</c:v>
                </c:pt>
                <c:pt idx="117">
                  <c:v>6004</c:v>
                </c:pt>
                <c:pt idx="118">
                  <c:v>5927</c:v>
                </c:pt>
                <c:pt idx="119">
                  <c:v>5995</c:v>
                </c:pt>
                <c:pt idx="120">
                  <c:v>5737</c:v>
                </c:pt>
                <c:pt idx="121">
                  <c:v>6000</c:v>
                </c:pt>
                <c:pt idx="122">
                  <c:v>6093</c:v>
                </c:pt>
                <c:pt idx="123">
                  <c:v>5643</c:v>
                </c:pt>
                <c:pt idx="124">
                  <c:v>5788</c:v>
                </c:pt>
                <c:pt idx="125">
                  <c:v>6165</c:v>
                </c:pt>
                <c:pt idx="126">
                  <c:v>6066</c:v>
                </c:pt>
                <c:pt idx="127">
                  <c:v>6115</c:v>
                </c:pt>
                <c:pt idx="128">
                  <c:v>5842</c:v>
                </c:pt>
                <c:pt idx="129">
                  <c:v>6035</c:v>
                </c:pt>
                <c:pt idx="130">
                  <c:v>6237</c:v>
                </c:pt>
                <c:pt idx="131">
                  <c:v>5990</c:v>
                </c:pt>
                <c:pt idx="132">
                  <c:v>5926</c:v>
                </c:pt>
                <c:pt idx="133">
                  <c:v>6064</c:v>
                </c:pt>
                <c:pt idx="134">
                  <c:v>5896</c:v>
                </c:pt>
                <c:pt idx="135">
                  <c:v>6182</c:v>
                </c:pt>
                <c:pt idx="136">
                  <c:v>6243</c:v>
                </c:pt>
                <c:pt idx="137">
                  <c:v>5918</c:v>
                </c:pt>
                <c:pt idx="138">
                  <c:v>6064</c:v>
                </c:pt>
                <c:pt idx="139">
                  <c:v>6166</c:v>
                </c:pt>
                <c:pt idx="140">
                  <c:v>5931</c:v>
                </c:pt>
                <c:pt idx="141">
                  <c:v>6021</c:v>
                </c:pt>
                <c:pt idx="142">
                  <c:v>5849</c:v>
                </c:pt>
                <c:pt idx="143">
                  <c:v>6023</c:v>
                </c:pt>
                <c:pt idx="144">
                  <c:v>6119</c:v>
                </c:pt>
                <c:pt idx="145">
                  <c:v>5934</c:v>
                </c:pt>
                <c:pt idx="146">
                  <c:v>5999</c:v>
                </c:pt>
                <c:pt idx="147">
                  <c:v>5673</c:v>
                </c:pt>
                <c:pt idx="148">
                  <c:v>6003</c:v>
                </c:pt>
                <c:pt idx="149">
                  <c:v>5985</c:v>
                </c:pt>
                <c:pt idx="150">
                  <c:v>5976</c:v>
                </c:pt>
                <c:pt idx="151">
                  <c:v>6236</c:v>
                </c:pt>
                <c:pt idx="152">
                  <c:v>5834</c:v>
                </c:pt>
                <c:pt idx="153">
                  <c:v>5758</c:v>
                </c:pt>
                <c:pt idx="154">
                  <c:v>6018</c:v>
                </c:pt>
                <c:pt idx="155">
                  <c:v>5681</c:v>
                </c:pt>
                <c:pt idx="156">
                  <c:v>5960</c:v>
                </c:pt>
                <c:pt idx="157">
                  <c:v>5864</c:v>
                </c:pt>
                <c:pt idx="158">
                  <c:v>6202</c:v>
                </c:pt>
                <c:pt idx="159">
                  <c:v>6013</c:v>
                </c:pt>
                <c:pt idx="160">
                  <c:v>5808</c:v>
                </c:pt>
                <c:pt idx="161">
                  <c:v>5797</c:v>
                </c:pt>
                <c:pt idx="162">
                  <c:v>5601</c:v>
                </c:pt>
                <c:pt idx="163">
                  <c:v>6137</c:v>
                </c:pt>
                <c:pt idx="164">
                  <c:v>5840</c:v>
                </c:pt>
                <c:pt idx="165">
                  <c:v>5895</c:v>
                </c:pt>
                <c:pt idx="166">
                  <c:v>5960</c:v>
                </c:pt>
                <c:pt idx="167">
                  <c:v>5701</c:v>
                </c:pt>
                <c:pt idx="168">
                  <c:v>5778</c:v>
                </c:pt>
                <c:pt idx="169">
                  <c:v>6161</c:v>
                </c:pt>
                <c:pt idx="170">
                  <c:v>5967</c:v>
                </c:pt>
                <c:pt idx="171">
                  <c:v>5831</c:v>
                </c:pt>
                <c:pt idx="172">
                  <c:v>5931</c:v>
                </c:pt>
                <c:pt idx="173">
                  <c:v>5886</c:v>
                </c:pt>
                <c:pt idx="174">
                  <c:v>5862</c:v>
                </c:pt>
                <c:pt idx="175">
                  <c:v>6032</c:v>
                </c:pt>
                <c:pt idx="176">
                  <c:v>5932</c:v>
                </c:pt>
                <c:pt idx="177">
                  <c:v>6099</c:v>
                </c:pt>
                <c:pt idx="178">
                  <c:v>5986</c:v>
                </c:pt>
                <c:pt idx="179">
                  <c:v>5922</c:v>
                </c:pt>
                <c:pt idx="180">
                  <c:v>5879</c:v>
                </c:pt>
                <c:pt idx="181">
                  <c:v>5876</c:v>
                </c:pt>
                <c:pt idx="182">
                  <c:v>5839</c:v>
                </c:pt>
                <c:pt idx="183">
                  <c:v>5776</c:v>
                </c:pt>
                <c:pt idx="184">
                  <c:v>6090</c:v>
                </c:pt>
                <c:pt idx="185">
                  <c:v>5863</c:v>
                </c:pt>
                <c:pt idx="186">
                  <c:v>5710</c:v>
                </c:pt>
                <c:pt idx="187">
                  <c:v>5903</c:v>
                </c:pt>
                <c:pt idx="188">
                  <c:v>5719</c:v>
                </c:pt>
                <c:pt idx="189">
                  <c:v>5980</c:v>
                </c:pt>
                <c:pt idx="190">
                  <c:v>6064</c:v>
                </c:pt>
                <c:pt idx="191">
                  <c:v>5972</c:v>
                </c:pt>
                <c:pt idx="192">
                  <c:v>5989</c:v>
                </c:pt>
                <c:pt idx="193">
                  <c:v>5734</c:v>
                </c:pt>
                <c:pt idx="194">
                  <c:v>5635</c:v>
                </c:pt>
                <c:pt idx="195">
                  <c:v>5846</c:v>
                </c:pt>
                <c:pt idx="196">
                  <c:v>6118</c:v>
                </c:pt>
                <c:pt idx="197">
                  <c:v>6149</c:v>
                </c:pt>
                <c:pt idx="198">
                  <c:v>6190</c:v>
                </c:pt>
                <c:pt idx="199">
                  <c:v>6058</c:v>
                </c:pt>
                <c:pt idx="200">
                  <c:v>6044</c:v>
                </c:pt>
                <c:pt idx="201">
                  <c:v>5941</c:v>
                </c:pt>
                <c:pt idx="202">
                  <c:v>6031</c:v>
                </c:pt>
                <c:pt idx="203">
                  <c:v>6199</c:v>
                </c:pt>
                <c:pt idx="204">
                  <c:v>6105</c:v>
                </c:pt>
                <c:pt idx="205">
                  <c:v>6096</c:v>
                </c:pt>
                <c:pt idx="206">
                  <c:v>5904</c:v>
                </c:pt>
                <c:pt idx="207">
                  <c:v>6214</c:v>
                </c:pt>
                <c:pt idx="208">
                  <c:v>6010</c:v>
                </c:pt>
                <c:pt idx="209">
                  <c:v>6169</c:v>
                </c:pt>
                <c:pt idx="210">
                  <c:v>6212</c:v>
                </c:pt>
                <c:pt idx="211">
                  <c:v>6026</c:v>
                </c:pt>
                <c:pt idx="212">
                  <c:v>6161</c:v>
                </c:pt>
                <c:pt idx="213">
                  <c:v>5970</c:v>
                </c:pt>
                <c:pt idx="214">
                  <c:v>6206</c:v>
                </c:pt>
                <c:pt idx="215">
                  <c:v>6269</c:v>
                </c:pt>
                <c:pt idx="216">
                  <c:v>6123</c:v>
                </c:pt>
                <c:pt idx="217">
                  <c:v>6355</c:v>
                </c:pt>
                <c:pt idx="218">
                  <c:v>6020</c:v>
                </c:pt>
                <c:pt idx="219">
                  <c:v>5865</c:v>
                </c:pt>
                <c:pt idx="220">
                  <c:v>5971</c:v>
                </c:pt>
                <c:pt idx="221">
                  <c:v>6108</c:v>
                </c:pt>
                <c:pt idx="222">
                  <c:v>6208</c:v>
                </c:pt>
                <c:pt idx="223">
                  <c:v>6119</c:v>
                </c:pt>
                <c:pt idx="224">
                  <c:v>6012</c:v>
                </c:pt>
                <c:pt idx="225">
                  <c:v>5819</c:v>
                </c:pt>
                <c:pt idx="226">
                  <c:v>5840</c:v>
                </c:pt>
                <c:pt idx="227">
                  <c:v>6013</c:v>
                </c:pt>
                <c:pt idx="228">
                  <c:v>6174</c:v>
                </c:pt>
                <c:pt idx="229">
                  <c:v>6114</c:v>
                </c:pt>
                <c:pt idx="230">
                  <c:v>6133</c:v>
                </c:pt>
                <c:pt idx="231">
                  <c:v>5854</c:v>
                </c:pt>
                <c:pt idx="232">
                  <c:v>5906</c:v>
                </c:pt>
                <c:pt idx="233">
                  <c:v>5888</c:v>
                </c:pt>
                <c:pt idx="234">
                  <c:v>6118</c:v>
                </c:pt>
                <c:pt idx="235">
                  <c:v>5991</c:v>
                </c:pt>
                <c:pt idx="236">
                  <c:v>5881</c:v>
                </c:pt>
                <c:pt idx="237">
                  <c:v>5920</c:v>
                </c:pt>
                <c:pt idx="238">
                  <c:v>6076</c:v>
                </c:pt>
                <c:pt idx="239">
                  <c:v>6112</c:v>
                </c:pt>
                <c:pt idx="240">
                  <c:v>5622</c:v>
                </c:pt>
                <c:pt idx="241">
                  <c:v>5927</c:v>
                </c:pt>
                <c:pt idx="242">
                  <c:v>5889</c:v>
                </c:pt>
                <c:pt idx="243">
                  <c:v>6067</c:v>
                </c:pt>
                <c:pt idx="244">
                  <c:v>5909</c:v>
                </c:pt>
                <c:pt idx="245">
                  <c:v>5773</c:v>
                </c:pt>
                <c:pt idx="246">
                  <c:v>6057</c:v>
                </c:pt>
                <c:pt idx="247">
                  <c:v>5754</c:v>
                </c:pt>
                <c:pt idx="248">
                  <c:v>5896</c:v>
                </c:pt>
                <c:pt idx="249">
                  <c:v>5945</c:v>
                </c:pt>
                <c:pt idx="250">
                  <c:v>5732</c:v>
                </c:pt>
                <c:pt idx="251">
                  <c:v>5955</c:v>
                </c:pt>
                <c:pt idx="252">
                  <c:v>6000</c:v>
                </c:pt>
                <c:pt idx="253">
                  <c:v>5678</c:v>
                </c:pt>
                <c:pt idx="254">
                  <c:v>6053</c:v>
                </c:pt>
                <c:pt idx="255">
                  <c:v>5801</c:v>
                </c:pt>
                <c:pt idx="256">
                  <c:v>5918</c:v>
                </c:pt>
                <c:pt idx="257">
                  <c:v>6052</c:v>
                </c:pt>
                <c:pt idx="258">
                  <c:v>5863</c:v>
                </c:pt>
                <c:pt idx="259">
                  <c:v>6388</c:v>
                </c:pt>
                <c:pt idx="260">
                  <c:v>6005</c:v>
                </c:pt>
                <c:pt idx="261">
                  <c:v>5753</c:v>
                </c:pt>
                <c:pt idx="262">
                  <c:v>5864</c:v>
                </c:pt>
                <c:pt idx="263">
                  <c:v>5452</c:v>
                </c:pt>
                <c:pt idx="264">
                  <c:v>5923</c:v>
                </c:pt>
                <c:pt idx="265">
                  <c:v>5928</c:v>
                </c:pt>
                <c:pt idx="266">
                  <c:v>5790</c:v>
                </c:pt>
                <c:pt idx="267">
                  <c:v>5937</c:v>
                </c:pt>
                <c:pt idx="268">
                  <c:v>5985</c:v>
                </c:pt>
                <c:pt idx="269">
                  <c:v>5885</c:v>
                </c:pt>
                <c:pt idx="270">
                  <c:v>5766</c:v>
                </c:pt>
                <c:pt idx="271">
                  <c:v>5686</c:v>
                </c:pt>
                <c:pt idx="272">
                  <c:v>5789</c:v>
                </c:pt>
                <c:pt idx="273">
                  <c:v>5992</c:v>
                </c:pt>
                <c:pt idx="274">
                  <c:v>5811</c:v>
                </c:pt>
                <c:pt idx="275">
                  <c:v>5557</c:v>
                </c:pt>
                <c:pt idx="276">
                  <c:v>5999</c:v>
                </c:pt>
                <c:pt idx="277">
                  <c:v>5721</c:v>
                </c:pt>
                <c:pt idx="278">
                  <c:v>5790</c:v>
                </c:pt>
                <c:pt idx="279">
                  <c:v>6094</c:v>
                </c:pt>
                <c:pt idx="280">
                  <c:v>5903</c:v>
                </c:pt>
                <c:pt idx="281">
                  <c:v>5831</c:v>
                </c:pt>
                <c:pt idx="282">
                  <c:v>5936</c:v>
                </c:pt>
                <c:pt idx="283">
                  <c:v>6234</c:v>
                </c:pt>
                <c:pt idx="284">
                  <c:v>5892</c:v>
                </c:pt>
                <c:pt idx="285">
                  <c:v>5572</c:v>
                </c:pt>
                <c:pt idx="286">
                  <c:v>5933</c:v>
                </c:pt>
                <c:pt idx="287">
                  <c:v>5786</c:v>
                </c:pt>
                <c:pt idx="288">
                  <c:v>6036</c:v>
                </c:pt>
                <c:pt idx="289">
                  <c:v>5753</c:v>
                </c:pt>
                <c:pt idx="290">
                  <c:v>6027</c:v>
                </c:pt>
                <c:pt idx="291">
                  <c:v>5795</c:v>
                </c:pt>
                <c:pt idx="292">
                  <c:v>5729</c:v>
                </c:pt>
                <c:pt idx="293">
                  <c:v>5853</c:v>
                </c:pt>
                <c:pt idx="294">
                  <c:v>5748</c:v>
                </c:pt>
                <c:pt idx="295">
                  <c:v>5930</c:v>
                </c:pt>
                <c:pt idx="296">
                  <c:v>6107</c:v>
                </c:pt>
                <c:pt idx="297">
                  <c:v>5839</c:v>
                </c:pt>
                <c:pt idx="298">
                  <c:v>5907</c:v>
                </c:pt>
                <c:pt idx="299">
                  <c:v>5841</c:v>
                </c:pt>
                <c:pt idx="300">
                  <c:v>5889</c:v>
                </c:pt>
                <c:pt idx="301">
                  <c:v>5870</c:v>
                </c:pt>
                <c:pt idx="302">
                  <c:v>5891</c:v>
                </c:pt>
                <c:pt idx="303">
                  <c:v>5898</c:v>
                </c:pt>
                <c:pt idx="304">
                  <c:v>5739</c:v>
                </c:pt>
                <c:pt idx="305">
                  <c:v>5892</c:v>
                </c:pt>
                <c:pt idx="306">
                  <c:v>5807</c:v>
                </c:pt>
                <c:pt idx="307">
                  <c:v>5893</c:v>
                </c:pt>
                <c:pt idx="308">
                  <c:v>5954</c:v>
                </c:pt>
                <c:pt idx="309">
                  <c:v>5898</c:v>
                </c:pt>
                <c:pt idx="310">
                  <c:v>5673</c:v>
                </c:pt>
                <c:pt idx="311">
                  <c:v>5596</c:v>
                </c:pt>
                <c:pt idx="312">
                  <c:v>5806</c:v>
                </c:pt>
                <c:pt idx="313">
                  <c:v>5711</c:v>
                </c:pt>
                <c:pt idx="314">
                  <c:v>5545</c:v>
                </c:pt>
                <c:pt idx="315">
                  <c:v>6057</c:v>
                </c:pt>
                <c:pt idx="316">
                  <c:v>5894</c:v>
                </c:pt>
                <c:pt idx="317">
                  <c:v>5818</c:v>
                </c:pt>
                <c:pt idx="318">
                  <c:v>5803</c:v>
                </c:pt>
                <c:pt idx="319">
                  <c:v>5899</c:v>
                </c:pt>
                <c:pt idx="320">
                  <c:v>5816</c:v>
                </c:pt>
                <c:pt idx="321">
                  <c:v>5745</c:v>
                </c:pt>
                <c:pt idx="322">
                  <c:v>5978</c:v>
                </c:pt>
                <c:pt idx="323">
                  <c:v>5948</c:v>
                </c:pt>
                <c:pt idx="324">
                  <c:v>6143</c:v>
                </c:pt>
                <c:pt idx="325">
                  <c:v>5882</c:v>
                </c:pt>
                <c:pt idx="326">
                  <c:v>5796</c:v>
                </c:pt>
                <c:pt idx="327">
                  <c:v>5944</c:v>
                </c:pt>
                <c:pt idx="328">
                  <c:v>5908</c:v>
                </c:pt>
                <c:pt idx="329">
                  <c:v>5835</c:v>
                </c:pt>
                <c:pt idx="330">
                  <c:v>5856</c:v>
                </c:pt>
                <c:pt idx="331">
                  <c:v>5778</c:v>
                </c:pt>
                <c:pt idx="332">
                  <c:v>5900</c:v>
                </c:pt>
                <c:pt idx="333">
                  <c:v>5629</c:v>
                </c:pt>
                <c:pt idx="334">
                  <c:v>6154</c:v>
                </c:pt>
                <c:pt idx="335">
                  <c:v>5927</c:v>
                </c:pt>
                <c:pt idx="336">
                  <c:v>5754</c:v>
                </c:pt>
                <c:pt idx="337">
                  <c:v>5813</c:v>
                </c:pt>
                <c:pt idx="338">
                  <c:v>5905</c:v>
                </c:pt>
                <c:pt idx="339">
                  <c:v>6171</c:v>
                </c:pt>
                <c:pt idx="340">
                  <c:v>5944</c:v>
                </c:pt>
                <c:pt idx="341">
                  <c:v>5814</c:v>
                </c:pt>
                <c:pt idx="342">
                  <c:v>5742</c:v>
                </c:pt>
                <c:pt idx="343">
                  <c:v>5985</c:v>
                </c:pt>
                <c:pt idx="344">
                  <c:v>6104</c:v>
                </c:pt>
                <c:pt idx="345">
                  <c:v>5891</c:v>
                </c:pt>
                <c:pt idx="346">
                  <c:v>5785</c:v>
                </c:pt>
                <c:pt idx="347">
                  <c:v>6185</c:v>
                </c:pt>
                <c:pt idx="348">
                  <c:v>5576</c:v>
                </c:pt>
                <c:pt idx="349">
                  <c:v>5979</c:v>
                </c:pt>
                <c:pt idx="350">
                  <c:v>6153</c:v>
                </c:pt>
                <c:pt idx="351">
                  <c:v>5657</c:v>
                </c:pt>
                <c:pt idx="352">
                  <c:v>5672</c:v>
                </c:pt>
                <c:pt idx="353">
                  <c:v>5867</c:v>
                </c:pt>
                <c:pt idx="354">
                  <c:v>5618</c:v>
                </c:pt>
                <c:pt idx="355">
                  <c:v>5730</c:v>
                </c:pt>
                <c:pt idx="356">
                  <c:v>5900</c:v>
                </c:pt>
                <c:pt idx="357">
                  <c:v>5866</c:v>
                </c:pt>
                <c:pt idx="358">
                  <c:v>6068</c:v>
                </c:pt>
                <c:pt idx="359">
                  <c:v>559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427-467D-89F7-DF68DE5F53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10301264"/>
        <c:axId val="910301624"/>
      </c:scatterChart>
      <c:valAx>
        <c:axId val="9103012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1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point</a:t>
                </a:r>
                <a:endParaRPr lang="zh-CN" altLang="en-US" sz="11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1569492370020716"/>
              <c:y val="0.880735971389040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10301624"/>
        <c:crosses val="autoZero"/>
        <c:crossBetween val="midCat"/>
      </c:valAx>
      <c:valAx>
        <c:axId val="9103016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1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ime series value</a:t>
                </a:r>
                <a:endParaRPr lang="zh-CN" altLang="en-US" sz="11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0_ 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103012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OLD</a:t>
            </a:r>
            <a:r>
              <a:rPr lang="en-US" altLang="zh-CN" b="1" baseline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ime series plot of raw data for a subject in </a:t>
            </a:r>
            <a:r>
              <a:rPr lang="en-US" altLang="zh-CN" b="1" baseline="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c</a:t>
            </a:r>
            <a:r>
              <a:rPr lang="en-US" altLang="zh-CN" b="1" baseline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roup </a:t>
            </a:r>
            <a:endParaRPr lang="en-US" altLang="zh-CN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Sheet3!$A$1</c:f>
              <c:strCache>
                <c:ptCount val="1"/>
                <c:pt idx="0">
                  <c:v>hc_sub_004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yVal>
            <c:numRef>
              <c:f>Sheet3!$A$2:$A$361</c:f>
              <c:numCache>
                <c:formatCode>0_ </c:formatCode>
                <c:ptCount val="360"/>
                <c:pt idx="0">
                  <c:v>4689</c:v>
                </c:pt>
                <c:pt idx="1">
                  <c:v>4331</c:v>
                </c:pt>
                <c:pt idx="2">
                  <c:v>4494</c:v>
                </c:pt>
                <c:pt idx="3">
                  <c:v>4755</c:v>
                </c:pt>
                <c:pt idx="4">
                  <c:v>4327</c:v>
                </c:pt>
                <c:pt idx="5">
                  <c:v>4173</c:v>
                </c:pt>
                <c:pt idx="6">
                  <c:v>4285</c:v>
                </c:pt>
                <c:pt idx="7">
                  <c:v>4596</c:v>
                </c:pt>
                <c:pt idx="8">
                  <c:v>4489</c:v>
                </c:pt>
                <c:pt idx="9">
                  <c:v>4535</c:v>
                </c:pt>
                <c:pt idx="10">
                  <c:v>4725</c:v>
                </c:pt>
                <c:pt idx="11">
                  <c:v>4399</c:v>
                </c:pt>
                <c:pt idx="12">
                  <c:v>4180</c:v>
                </c:pt>
                <c:pt idx="13">
                  <c:v>4791</c:v>
                </c:pt>
                <c:pt idx="14">
                  <c:v>4670</c:v>
                </c:pt>
                <c:pt idx="15">
                  <c:v>4149</c:v>
                </c:pt>
                <c:pt idx="16">
                  <c:v>4216</c:v>
                </c:pt>
                <c:pt idx="17">
                  <c:v>4646</c:v>
                </c:pt>
                <c:pt idx="18">
                  <c:v>4701</c:v>
                </c:pt>
                <c:pt idx="19">
                  <c:v>4295</c:v>
                </c:pt>
                <c:pt idx="20">
                  <c:v>4439</c:v>
                </c:pt>
                <c:pt idx="21">
                  <c:v>4621</c:v>
                </c:pt>
                <c:pt idx="22">
                  <c:v>4266</c:v>
                </c:pt>
                <c:pt idx="23">
                  <c:v>4366</c:v>
                </c:pt>
                <c:pt idx="24">
                  <c:v>4456</c:v>
                </c:pt>
                <c:pt idx="25">
                  <c:v>4065</c:v>
                </c:pt>
                <c:pt idx="26">
                  <c:v>4199</c:v>
                </c:pt>
                <c:pt idx="27">
                  <c:v>4437</c:v>
                </c:pt>
                <c:pt idx="28">
                  <c:v>4405</c:v>
                </c:pt>
                <c:pt idx="29">
                  <c:v>4386</c:v>
                </c:pt>
                <c:pt idx="30">
                  <c:v>4158</c:v>
                </c:pt>
                <c:pt idx="31">
                  <c:v>4629</c:v>
                </c:pt>
                <c:pt idx="32">
                  <c:v>4428</c:v>
                </c:pt>
                <c:pt idx="33">
                  <c:v>4213</c:v>
                </c:pt>
                <c:pt idx="34">
                  <c:v>4361</c:v>
                </c:pt>
                <c:pt idx="35">
                  <c:v>4381</c:v>
                </c:pt>
                <c:pt idx="36">
                  <c:v>4317</c:v>
                </c:pt>
                <c:pt idx="37">
                  <c:v>3966</c:v>
                </c:pt>
                <c:pt idx="38">
                  <c:v>4284</c:v>
                </c:pt>
                <c:pt idx="39">
                  <c:v>4173</c:v>
                </c:pt>
                <c:pt idx="40">
                  <c:v>4379</c:v>
                </c:pt>
                <c:pt idx="41">
                  <c:v>4333</c:v>
                </c:pt>
                <c:pt idx="42">
                  <c:v>4473</c:v>
                </c:pt>
                <c:pt idx="43">
                  <c:v>4350</c:v>
                </c:pt>
                <c:pt idx="44">
                  <c:v>4610</c:v>
                </c:pt>
                <c:pt idx="45">
                  <c:v>4554</c:v>
                </c:pt>
                <c:pt idx="46">
                  <c:v>4524</c:v>
                </c:pt>
                <c:pt idx="47">
                  <c:v>3994</c:v>
                </c:pt>
                <c:pt idx="48">
                  <c:v>4225</c:v>
                </c:pt>
                <c:pt idx="49">
                  <c:v>4621</c:v>
                </c:pt>
                <c:pt idx="50">
                  <c:v>4501</c:v>
                </c:pt>
                <c:pt idx="51">
                  <c:v>4465</c:v>
                </c:pt>
                <c:pt idx="52">
                  <c:v>4841</c:v>
                </c:pt>
                <c:pt idx="53">
                  <c:v>4420</c:v>
                </c:pt>
                <c:pt idx="54">
                  <c:v>4269</c:v>
                </c:pt>
                <c:pt idx="55">
                  <c:v>4551</c:v>
                </c:pt>
                <c:pt idx="56">
                  <c:v>4496</c:v>
                </c:pt>
                <c:pt idx="57">
                  <c:v>4230</c:v>
                </c:pt>
                <c:pt idx="58">
                  <c:v>4439</c:v>
                </c:pt>
                <c:pt idx="59">
                  <c:v>4208</c:v>
                </c:pt>
                <c:pt idx="60">
                  <c:v>4548</c:v>
                </c:pt>
                <c:pt idx="61">
                  <c:v>4211</c:v>
                </c:pt>
                <c:pt idx="62">
                  <c:v>4311</c:v>
                </c:pt>
                <c:pt idx="63">
                  <c:v>4530</c:v>
                </c:pt>
                <c:pt idx="64">
                  <c:v>4351</c:v>
                </c:pt>
                <c:pt idx="65">
                  <c:v>4415</c:v>
                </c:pt>
                <c:pt idx="66">
                  <c:v>4055</c:v>
                </c:pt>
                <c:pt idx="67">
                  <c:v>4646</c:v>
                </c:pt>
                <c:pt idx="68">
                  <c:v>4541</c:v>
                </c:pt>
                <c:pt idx="69">
                  <c:v>4438</c:v>
                </c:pt>
                <c:pt idx="70">
                  <c:v>4593</c:v>
                </c:pt>
                <c:pt idx="71">
                  <c:v>4438</c:v>
                </c:pt>
                <c:pt idx="72">
                  <c:v>4317</c:v>
                </c:pt>
                <c:pt idx="73">
                  <c:v>4265</c:v>
                </c:pt>
                <c:pt idx="74">
                  <c:v>4543</c:v>
                </c:pt>
                <c:pt idx="75">
                  <c:v>4527</c:v>
                </c:pt>
                <c:pt idx="76">
                  <c:v>4438</c:v>
                </c:pt>
                <c:pt idx="77">
                  <c:v>4301</c:v>
                </c:pt>
                <c:pt idx="78">
                  <c:v>4434</c:v>
                </c:pt>
                <c:pt idx="79">
                  <c:v>4646</c:v>
                </c:pt>
                <c:pt idx="80">
                  <c:v>4404</c:v>
                </c:pt>
                <c:pt idx="81">
                  <c:v>4123</c:v>
                </c:pt>
                <c:pt idx="82">
                  <c:v>4662</c:v>
                </c:pt>
                <c:pt idx="83">
                  <c:v>4707</c:v>
                </c:pt>
                <c:pt idx="84">
                  <c:v>4686</c:v>
                </c:pt>
                <c:pt idx="85">
                  <c:v>4403</c:v>
                </c:pt>
                <c:pt idx="86">
                  <c:v>4337</c:v>
                </c:pt>
                <c:pt idx="87">
                  <c:v>4533</c:v>
                </c:pt>
                <c:pt idx="88">
                  <c:v>4354</c:v>
                </c:pt>
                <c:pt idx="89">
                  <c:v>4347</c:v>
                </c:pt>
                <c:pt idx="90">
                  <c:v>4411</c:v>
                </c:pt>
                <c:pt idx="91">
                  <c:v>4285</c:v>
                </c:pt>
                <c:pt idx="92">
                  <c:v>4464</c:v>
                </c:pt>
                <c:pt idx="93">
                  <c:v>4663</c:v>
                </c:pt>
                <c:pt idx="94">
                  <c:v>4402</c:v>
                </c:pt>
                <c:pt idx="95">
                  <c:v>4357</c:v>
                </c:pt>
                <c:pt idx="96">
                  <c:v>4775</c:v>
                </c:pt>
                <c:pt idx="97">
                  <c:v>4551</c:v>
                </c:pt>
                <c:pt idx="98">
                  <c:v>4147</c:v>
                </c:pt>
                <c:pt idx="99">
                  <c:v>4701</c:v>
                </c:pt>
                <c:pt idx="100">
                  <c:v>4567</c:v>
                </c:pt>
                <c:pt idx="101">
                  <c:v>3765</c:v>
                </c:pt>
                <c:pt idx="102">
                  <c:v>4382</c:v>
                </c:pt>
                <c:pt idx="103">
                  <c:v>4557</c:v>
                </c:pt>
                <c:pt idx="104">
                  <c:v>4194</c:v>
                </c:pt>
                <c:pt idx="105">
                  <c:v>4260</c:v>
                </c:pt>
                <c:pt idx="106">
                  <c:v>4605</c:v>
                </c:pt>
                <c:pt idx="107">
                  <c:v>4747</c:v>
                </c:pt>
                <c:pt idx="108">
                  <c:v>4097</c:v>
                </c:pt>
                <c:pt idx="109">
                  <c:v>4380</c:v>
                </c:pt>
                <c:pt idx="110">
                  <c:v>4402</c:v>
                </c:pt>
                <c:pt idx="111">
                  <c:v>4355</c:v>
                </c:pt>
                <c:pt idx="112">
                  <c:v>4176</c:v>
                </c:pt>
                <c:pt idx="113">
                  <c:v>4253</c:v>
                </c:pt>
                <c:pt idx="114">
                  <c:v>4295</c:v>
                </c:pt>
                <c:pt idx="115">
                  <c:v>4166</c:v>
                </c:pt>
                <c:pt idx="116">
                  <c:v>4477</c:v>
                </c:pt>
                <c:pt idx="117">
                  <c:v>4197</c:v>
                </c:pt>
                <c:pt idx="118">
                  <c:v>4430</c:v>
                </c:pt>
                <c:pt idx="119">
                  <c:v>4488</c:v>
                </c:pt>
                <c:pt idx="120">
                  <c:v>4610</c:v>
                </c:pt>
                <c:pt idx="121">
                  <c:v>4459</c:v>
                </c:pt>
                <c:pt idx="122">
                  <c:v>4300</c:v>
                </c:pt>
                <c:pt idx="123">
                  <c:v>4592</c:v>
                </c:pt>
                <c:pt idx="124">
                  <c:v>4366</c:v>
                </c:pt>
                <c:pt idx="125">
                  <c:v>4496</c:v>
                </c:pt>
                <c:pt idx="126">
                  <c:v>4112</c:v>
                </c:pt>
                <c:pt idx="127">
                  <c:v>4551</c:v>
                </c:pt>
                <c:pt idx="128">
                  <c:v>4596</c:v>
                </c:pt>
                <c:pt idx="129">
                  <c:v>4571</c:v>
                </c:pt>
                <c:pt idx="130">
                  <c:v>4332</c:v>
                </c:pt>
                <c:pt idx="131">
                  <c:v>4425</c:v>
                </c:pt>
                <c:pt idx="132">
                  <c:v>4519</c:v>
                </c:pt>
                <c:pt idx="133">
                  <c:v>4557</c:v>
                </c:pt>
                <c:pt idx="134">
                  <c:v>3956</c:v>
                </c:pt>
                <c:pt idx="135">
                  <c:v>4137</c:v>
                </c:pt>
                <c:pt idx="136">
                  <c:v>4262</c:v>
                </c:pt>
                <c:pt idx="137">
                  <c:v>4367</c:v>
                </c:pt>
                <c:pt idx="138">
                  <c:v>4482</c:v>
                </c:pt>
                <c:pt idx="139">
                  <c:v>4264</c:v>
                </c:pt>
                <c:pt idx="140">
                  <c:v>4267</c:v>
                </c:pt>
                <c:pt idx="141">
                  <c:v>4256</c:v>
                </c:pt>
                <c:pt idx="142">
                  <c:v>4383</c:v>
                </c:pt>
                <c:pt idx="143">
                  <c:v>4094</c:v>
                </c:pt>
                <c:pt idx="144">
                  <c:v>4458</c:v>
                </c:pt>
                <c:pt idx="145">
                  <c:v>4365</c:v>
                </c:pt>
                <c:pt idx="146">
                  <c:v>4028</c:v>
                </c:pt>
                <c:pt idx="147">
                  <c:v>4557</c:v>
                </c:pt>
                <c:pt idx="148">
                  <c:v>4695</c:v>
                </c:pt>
                <c:pt idx="149">
                  <c:v>4503</c:v>
                </c:pt>
                <c:pt idx="150">
                  <c:v>4037</c:v>
                </c:pt>
                <c:pt idx="151">
                  <c:v>4424</c:v>
                </c:pt>
                <c:pt idx="152">
                  <c:v>4062</c:v>
                </c:pt>
                <c:pt idx="153">
                  <c:v>4447</c:v>
                </c:pt>
                <c:pt idx="154">
                  <c:v>4258</c:v>
                </c:pt>
                <c:pt idx="155">
                  <c:v>4287</c:v>
                </c:pt>
                <c:pt idx="156">
                  <c:v>3848</c:v>
                </c:pt>
                <c:pt idx="157">
                  <c:v>4047</c:v>
                </c:pt>
                <c:pt idx="158">
                  <c:v>4285</c:v>
                </c:pt>
                <c:pt idx="159">
                  <c:v>4250</c:v>
                </c:pt>
                <c:pt idx="160">
                  <c:v>4133</c:v>
                </c:pt>
                <c:pt idx="161">
                  <c:v>4260</c:v>
                </c:pt>
                <c:pt idx="162">
                  <c:v>4187</c:v>
                </c:pt>
                <c:pt idx="163">
                  <c:v>4634</c:v>
                </c:pt>
                <c:pt idx="164">
                  <c:v>4444</c:v>
                </c:pt>
                <c:pt idx="165">
                  <c:v>4195</c:v>
                </c:pt>
                <c:pt idx="166">
                  <c:v>4318</c:v>
                </c:pt>
                <c:pt idx="167">
                  <c:v>4533</c:v>
                </c:pt>
                <c:pt idx="168">
                  <c:v>4418</c:v>
                </c:pt>
                <c:pt idx="169">
                  <c:v>4182</c:v>
                </c:pt>
                <c:pt idx="170">
                  <c:v>4162</c:v>
                </c:pt>
                <c:pt idx="171">
                  <c:v>4639</c:v>
                </c:pt>
                <c:pt idx="172">
                  <c:v>4579</c:v>
                </c:pt>
                <c:pt idx="173">
                  <c:v>4399</c:v>
                </c:pt>
                <c:pt idx="174">
                  <c:v>4267</c:v>
                </c:pt>
                <c:pt idx="175">
                  <c:v>4101</c:v>
                </c:pt>
                <c:pt idx="176">
                  <c:v>4533</c:v>
                </c:pt>
                <c:pt idx="177">
                  <c:v>4391</c:v>
                </c:pt>
                <c:pt idx="178">
                  <c:v>4654</c:v>
                </c:pt>
                <c:pt idx="179">
                  <c:v>4176</c:v>
                </c:pt>
                <c:pt idx="180">
                  <c:v>4265</c:v>
                </c:pt>
                <c:pt idx="181">
                  <c:v>4243</c:v>
                </c:pt>
                <c:pt idx="182">
                  <c:v>4271</c:v>
                </c:pt>
                <c:pt idx="183">
                  <c:v>4201</c:v>
                </c:pt>
                <c:pt idx="184">
                  <c:v>4609</c:v>
                </c:pt>
                <c:pt idx="185">
                  <c:v>4356</c:v>
                </c:pt>
                <c:pt idx="186">
                  <c:v>4058</c:v>
                </c:pt>
                <c:pt idx="187">
                  <c:v>4138</c:v>
                </c:pt>
                <c:pt idx="188">
                  <c:v>4223</c:v>
                </c:pt>
                <c:pt idx="189">
                  <c:v>4082</c:v>
                </c:pt>
                <c:pt idx="190">
                  <c:v>4111</c:v>
                </c:pt>
                <c:pt idx="191">
                  <c:v>4401</c:v>
                </c:pt>
                <c:pt idx="192">
                  <c:v>4231</c:v>
                </c:pt>
                <c:pt idx="193">
                  <c:v>3971</c:v>
                </c:pt>
                <c:pt idx="194">
                  <c:v>4033</c:v>
                </c:pt>
                <c:pt idx="195">
                  <c:v>4302</c:v>
                </c:pt>
                <c:pt idx="196">
                  <c:v>4417</c:v>
                </c:pt>
                <c:pt idx="197">
                  <c:v>4402</c:v>
                </c:pt>
                <c:pt idx="198">
                  <c:v>4001</c:v>
                </c:pt>
                <c:pt idx="199">
                  <c:v>4339</c:v>
                </c:pt>
                <c:pt idx="200">
                  <c:v>3998</c:v>
                </c:pt>
                <c:pt idx="201">
                  <c:v>4348</c:v>
                </c:pt>
                <c:pt idx="202">
                  <c:v>4517</c:v>
                </c:pt>
                <c:pt idx="203">
                  <c:v>4295</c:v>
                </c:pt>
                <c:pt idx="204">
                  <c:v>4403</c:v>
                </c:pt>
                <c:pt idx="205">
                  <c:v>4305</c:v>
                </c:pt>
                <c:pt idx="206">
                  <c:v>4262</c:v>
                </c:pt>
                <c:pt idx="207">
                  <c:v>4199</c:v>
                </c:pt>
                <c:pt idx="208">
                  <c:v>4270</c:v>
                </c:pt>
                <c:pt idx="209">
                  <c:v>4003</c:v>
                </c:pt>
                <c:pt idx="210">
                  <c:v>3978</c:v>
                </c:pt>
                <c:pt idx="211">
                  <c:v>4331</c:v>
                </c:pt>
                <c:pt idx="212">
                  <c:v>4259</c:v>
                </c:pt>
                <c:pt idx="213">
                  <c:v>4280</c:v>
                </c:pt>
                <c:pt idx="214">
                  <c:v>4109</c:v>
                </c:pt>
                <c:pt idx="215">
                  <c:v>4321</c:v>
                </c:pt>
                <c:pt idx="216">
                  <c:v>4138</c:v>
                </c:pt>
                <c:pt idx="217">
                  <c:v>4161</c:v>
                </c:pt>
                <c:pt idx="218">
                  <c:v>4384</c:v>
                </c:pt>
                <c:pt idx="219">
                  <c:v>4467</c:v>
                </c:pt>
                <c:pt idx="220">
                  <c:v>4208</c:v>
                </c:pt>
                <c:pt idx="221">
                  <c:v>4394</c:v>
                </c:pt>
                <c:pt idx="222">
                  <c:v>4385</c:v>
                </c:pt>
                <c:pt idx="223">
                  <c:v>4313</c:v>
                </c:pt>
                <c:pt idx="224">
                  <c:v>4327</c:v>
                </c:pt>
                <c:pt idx="225">
                  <c:v>4353</c:v>
                </c:pt>
                <c:pt idx="226">
                  <c:v>4300</c:v>
                </c:pt>
                <c:pt idx="227">
                  <c:v>4315</c:v>
                </c:pt>
                <c:pt idx="228">
                  <c:v>4070</c:v>
                </c:pt>
                <c:pt idx="229">
                  <c:v>4043</c:v>
                </c:pt>
                <c:pt idx="230">
                  <c:v>4008</c:v>
                </c:pt>
                <c:pt idx="231">
                  <c:v>4182</c:v>
                </c:pt>
                <c:pt idx="232">
                  <c:v>4181</c:v>
                </c:pt>
                <c:pt idx="233">
                  <c:v>4248</c:v>
                </c:pt>
                <c:pt idx="234">
                  <c:v>4193</c:v>
                </c:pt>
                <c:pt idx="235">
                  <c:v>4126</c:v>
                </c:pt>
                <c:pt idx="236">
                  <c:v>4168</c:v>
                </c:pt>
                <c:pt idx="237">
                  <c:v>4113</c:v>
                </c:pt>
                <c:pt idx="238">
                  <c:v>4220</c:v>
                </c:pt>
                <c:pt idx="239">
                  <c:v>4117</c:v>
                </c:pt>
                <c:pt idx="240">
                  <c:v>4381</c:v>
                </c:pt>
                <c:pt idx="241">
                  <c:v>4155</c:v>
                </c:pt>
                <c:pt idx="242">
                  <c:v>4208</c:v>
                </c:pt>
                <c:pt idx="243">
                  <c:v>4282</c:v>
                </c:pt>
                <c:pt idx="244">
                  <c:v>4010</c:v>
                </c:pt>
                <c:pt idx="245">
                  <c:v>4150</c:v>
                </c:pt>
                <c:pt idx="246">
                  <c:v>4179</c:v>
                </c:pt>
                <c:pt idx="247">
                  <c:v>4158</c:v>
                </c:pt>
                <c:pt idx="248">
                  <c:v>3869</c:v>
                </c:pt>
                <c:pt idx="249">
                  <c:v>4371</c:v>
                </c:pt>
                <c:pt idx="250">
                  <c:v>4380</c:v>
                </c:pt>
                <c:pt idx="251">
                  <c:v>3975</c:v>
                </c:pt>
                <c:pt idx="252">
                  <c:v>4160</c:v>
                </c:pt>
                <c:pt idx="253">
                  <c:v>4213</c:v>
                </c:pt>
                <c:pt idx="254">
                  <c:v>4158</c:v>
                </c:pt>
                <c:pt idx="255">
                  <c:v>4259</c:v>
                </c:pt>
                <c:pt idx="256">
                  <c:v>4371</c:v>
                </c:pt>
                <c:pt idx="257">
                  <c:v>4251</c:v>
                </c:pt>
                <c:pt idx="258">
                  <c:v>3964</c:v>
                </c:pt>
                <c:pt idx="259">
                  <c:v>4083</c:v>
                </c:pt>
                <c:pt idx="260">
                  <c:v>4312</c:v>
                </c:pt>
                <c:pt idx="261">
                  <c:v>4252</c:v>
                </c:pt>
                <c:pt idx="262">
                  <c:v>4284</c:v>
                </c:pt>
                <c:pt idx="263">
                  <c:v>4241</c:v>
                </c:pt>
                <c:pt idx="264">
                  <c:v>4242</c:v>
                </c:pt>
                <c:pt idx="265">
                  <c:v>3943</c:v>
                </c:pt>
                <c:pt idx="266">
                  <c:v>3861</c:v>
                </c:pt>
                <c:pt idx="267">
                  <c:v>4207</c:v>
                </c:pt>
                <c:pt idx="268">
                  <c:v>4049</c:v>
                </c:pt>
                <c:pt idx="269">
                  <c:v>4046</c:v>
                </c:pt>
                <c:pt idx="270">
                  <c:v>4235</c:v>
                </c:pt>
                <c:pt idx="271">
                  <c:v>4135</c:v>
                </c:pt>
                <c:pt idx="272">
                  <c:v>3941</c:v>
                </c:pt>
                <c:pt idx="273">
                  <c:v>4265</c:v>
                </c:pt>
                <c:pt idx="274">
                  <c:v>4261</c:v>
                </c:pt>
                <c:pt idx="275">
                  <c:v>4063</c:v>
                </c:pt>
                <c:pt idx="276">
                  <c:v>4254</c:v>
                </c:pt>
                <c:pt idx="277">
                  <c:v>4136</c:v>
                </c:pt>
                <c:pt idx="278">
                  <c:v>4236</c:v>
                </c:pt>
                <c:pt idx="279">
                  <c:v>4131</c:v>
                </c:pt>
                <c:pt idx="280">
                  <c:v>4322</c:v>
                </c:pt>
                <c:pt idx="281">
                  <c:v>4067</c:v>
                </c:pt>
                <c:pt idx="282">
                  <c:v>4046</c:v>
                </c:pt>
                <c:pt idx="283">
                  <c:v>3898</c:v>
                </c:pt>
                <c:pt idx="284">
                  <c:v>4113</c:v>
                </c:pt>
                <c:pt idx="285">
                  <c:v>4247</c:v>
                </c:pt>
                <c:pt idx="286">
                  <c:v>4137</c:v>
                </c:pt>
                <c:pt idx="287">
                  <c:v>4228</c:v>
                </c:pt>
                <c:pt idx="288">
                  <c:v>3936</c:v>
                </c:pt>
                <c:pt idx="289">
                  <c:v>4233</c:v>
                </c:pt>
                <c:pt idx="290">
                  <c:v>3994</c:v>
                </c:pt>
                <c:pt idx="291">
                  <c:v>4167</c:v>
                </c:pt>
                <c:pt idx="292">
                  <c:v>3969</c:v>
                </c:pt>
                <c:pt idx="293">
                  <c:v>4199</c:v>
                </c:pt>
                <c:pt idx="294">
                  <c:v>4154</c:v>
                </c:pt>
                <c:pt idx="295">
                  <c:v>3869</c:v>
                </c:pt>
                <c:pt idx="296">
                  <c:v>4225</c:v>
                </c:pt>
                <c:pt idx="297">
                  <c:v>4091</c:v>
                </c:pt>
                <c:pt idx="298">
                  <c:v>4079</c:v>
                </c:pt>
                <c:pt idx="299">
                  <c:v>3926</c:v>
                </c:pt>
                <c:pt idx="300">
                  <c:v>3690</c:v>
                </c:pt>
                <c:pt idx="301">
                  <c:v>4171</c:v>
                </c:pt>
                <c:pt idx="302">
                  <c:v>4034</c:v>
                </c:pt>
                <c:pt idx="303">
                  <c:v>4369</c:v>
                </c:pt>
                <c:pt idx="304">
                  <c:v>4384</c:v>
                </c:pt>
                <c:pt idx="305">
                  <c:v>4150</c:v>
                </c:pt>
                <c:pt idx="306">
                  <c:v>4369</c:v>
                </c:pt>
                <c:pt idx="307">
                  <c:v>4124</c:v>
                </c:pt>
                <c:pt idx="308">
                  <c:v>3915</c:v>
                </c:pt>
                <c:pt idx="309">
                  <c:v>4074</c:v>
                </c:pt>
                <c:pt idx="310">
                  <c:v>4281</c:v>
                </c:pt>
                <c:pt idx="311">
                  <c:v>4147</c:v>
                </c:pt>
                <c:pt idx="312">
                  <c:v>4021</c:v>
                </c:pt>
                <c:pt idx="313">
                  <c:v>4457</c:v>
                </c:pt>
                <c:pt idx="314">
                  <c:v>4101</c:v>
                </c:pt>
                <c:pt idx="315">
                  <c:v>4071</c:v>
                </c:pt>
                <c:pt idx="316">
                  <c:v>4110</c:v>
                </c:pt>
                <c:pt idx="317">
                  <c:v>3986</c:v>
                </c:pt>
                <c:pt idx="318">
                  <c:v>3990</c:v>
                </c:pt>
                <c:pt idx="319">
                  <c:v>4165</c:v>
                </c:pt>
                <c:pt idx="320">
                  <c:v>4169</c:v>
                </c:pt>
                <c:pt idx="321">
                  <c:v>4098</c:v>
                </c:pt>
                <c:pt idx="322">
                  <c:v>3900</c:v>
                </c:pt>
                <c:pt idx="323">
                  <c:v>4273</c:v>
                </c:pt>
                <c:pt idx="324">
                  <c:v>4066</c:v>
                </c:pt>
                <c:pt idx="325">
                  <c:v>3927</c:v>
                </c:pt>
                <c:pt idx="326">
                  <c:v>3825</c:v>
                </c:pt>
                <c:pt idx="327">
                  <c:v>4081</c:v>
                </c:pt>
                <c:pt idx="328">
                  <c:v>4229</c:v>
                </c:pt>
                <c:pt idx="329">
                  <c:v>4082</c:v>
                </c:pt>
                <c:pt idx="330">
                  <c:v>4288</c:v>
                </c:pt>
                <c:pt idx="331">
                  <c:v>4364</c:v>
                </c:pt>
                <c:pt idx="332">
                  <c:v>4279</c:v>
                </c:pt>
                <c:pt idx="333">
                  <c:v>3940</c:v>
                </c:pt>
                <c:pt idx="334">
                  <c:v>4225</c:v>
                </c:pt>
                <c:pt idx="335">
                  <c:v>4068</c:v>
                </c:pt>
                <c:pt idx="336">
                  <c:v>3711</c:v>
                </c:pt>
                <c:pt idx="337">
                  <c:v>4056</c:v>
                </c:pt>
                <c:pt idx="338">
                  <c:v>4058</c:v>
                </c:pt>
                <c:pt idx="339">
                  <c:v>4006</c:v>
                </c:pt>
                <c:pt idx="340">
                  <c:v>4293</c:v>
                </c:pt>
                <c:pt idx="341">
                  <c:v>4196</c:v>
                </c:pt>
                <c:pt idx="342">
                  <c:v>4248</c:v>
                </c:pt>
                <c:pt idx="343">
                  <c:v>4385</c:v>
                </c:pt>
                <c:pt idx="344">
                  <c:v>4417</c:v>
                </c:pt>
                <c:pt idx="345">
                  <c:v>4091</c:v>
                </c:pt>
                <c:pt idx="346">
                  <c:v>4046</c:v>
                </c:pt>
                <c:pt idx="347">
                  <c:v>4345</c:v>
                </c:pt>
                <c:pt idx="348">
                  <c:v>3975</c:v>
                </c:pt>
                <c:pt idx="349">
                  <c:v>4232</c:v>
                </c:pt>
                <c:pt idx="350">
                  <c:v>4136</c:v>
                </c:pt>
                <c:pt idx="351">
                  <c:v>4256</c:v>
                </c:pt>
                <c:pt idx="352">
                  <c:v>4316</c:v>
                </c:pt>
                <c:pt idx="353">
                  <c:v>3805</c:v>
                </c:pt>
                <c:pt idx="354">
                  <c:v>4067</c:v>
                </c:pt>
                <c:pt idx="355">
                  <c:v>4132</c:v>
                </c:pt>
                <c:pt idx="356">
                  <c:v>4056</c:v>
                </c:pt>
                <c:pt idx="357">
                  <c:v>4557</c:v>
                </c:pt>
                <c:pt idx="358">
                  <c:v>4080</c:v>
                </c:pt>
                <c:pt idx="359">
                  <c:v>411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6CC-4737-816F-0156EA29EF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0253176"/>
        <c:axId val="950251016"/>
      </c:scatterChart>
      <c:valAx>
        <c:axId val="9502531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point</a:t>
                </a:r>
                <a:endParaRPr lang="zh-CN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50251016"/>
        <c:crosses val="autoZero"/>
        <c:crossBetween val="midCat"/>
      </c:valAx>
      <c:valAx>
        <c:axId val="950251016"/>
        <c:scaling>
          <c:orientation val="minMax"/>
          <c:max val="5000"/>
          <c:min val="36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1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Time series value</a:t>
                </a:r>
                <a:endParaRPr lang="zh-CN" altLang="en-US" sz="11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0_ 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9502531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830590-6E56-B695-A0BA-94EAF1CCCE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E1FA980-AF64-FAFA-0794-02A622DD02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0C4890-AB0F-D2B2-D453-0B41DB44BA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798C5F1-FB7E-D694-70E1-4DA357AD0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9DCA3E-C29E-DF56-3D16-47119AB14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557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F8E7D20-A68A-EDF1-DE11-3C0A106140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9A82666-B6DC-FA78-A6B7-5839F36255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04C1CB-0404-FCBD-16EC-890E03C62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4E33B04-54D2-31F1-D5C7-3C89D13B59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9EC3C5-0951-EC94-047A-4965C3FDB9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1437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EA21293-16D4-27A6-2C30-D3F11FDCA3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119B1F6-8913-5230-345F-0BAC5F4105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52A729-88AD-5E2D-E22F-600335647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F302AF-2FAA-65BE-4CF3-1651459E9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7240326-4F38-6D16-75AF-974CB5568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431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EE31DF-13CA-D96F-F17B-D7562BFEB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8EA68B6-AFC8-0471-DF5C-274C572287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DC9EF8-E89D-F5D0-130C-DD16BE52A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653E9E-B23F-E5F8-1AB0-14176CEEA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CA10EC-058A-3FD8-4654-0C1A1286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3787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AF5C17-5578-E2AD-C9B8-ADF089967B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753A1F5-5285-3B4A-B2D1-C51710B324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797CF66-F243-7D3B-EA51-E0759BC17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1F023E3-682F-FAF5-3148-F02552876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7DE2A5-F5FB-EDF5-A19A-4AF11EFA2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6836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55A042-41E4-16C6-8B5C-AC1E4E55F7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AF3747E-E536-5571-96F9-7FF65FD2CC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CCBC2F2-659A-231A-F0AF-8BA5266103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A02F40-756D-296B-CCFF-164498569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8589D4F-DC03-5FD1-CFEA-649674724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52F66D4-BFB8-932A-499A-3C9AEBB2D8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0323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DD08F2-DD60-E24E-DD84-E1FA263655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5D138F5-0C63-FFCB-95DA-4E6EB58D00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DBC0139-F6A4-CD09-097F-6D0239AB12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E535FF7-A60C-17F9-810E-10443591AF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9257354-6E0F-5420-2E6D-55A85E98E2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1433E0C-9450-FFAD-AEBD-150CFCD71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5C79AC6-9BB3-C330-7ACC-B6F8B46BB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6CB3157-02F8-1960-B266-A62ADFBA3E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8456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2B2AC7B-BD1D-031D-068F-859D131CD1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CF1DF02-66D3-F615-FA38-6054C892E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27F6771-8E6C-7486-6A1D-ECDD4BCB99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CA72CB2-5038-ED88-77D9-9E9880E75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0022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9EC0330-4A17-B420-2399-C80F125E0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9656851-3D12-E4E9-17B6-FC1346FAC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2C98542-2D7F-3A2A-4B47-7C1FCE2EE5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7003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8D7CC2-3F61-59D5-1686-8CA2A9E50E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C59155-97B9-3CA9-22CE-5242922AA4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8EC22EC-31C1-C9C8-DC15-DE63B5EEA2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6FDF2C4-1735-83B1-3834-53B9117E1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A4F5AD6-EEC7-2AD3-77DB-97316D2CC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A091C26-8BFC-1283-0D13-3548DE7D5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0385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D761D9-1E5E-2EF4-74F0-2EF9F8B6A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F1154EF-3898-B067-0E00-F66770D2EE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EEC23EB-7747-54C4-FDDD-FAD1143D61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B906838-5B8A-33DA-F6BF-197CA1E70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E4F291E-E2C8-8F68-A9CC-D2F85AB25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6177409-2179-5A8B-9A49-583A02D60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4788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358AA45-EA9F-49E5-7D1F-8C8F492303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2C2A425-F94C-B3BA-8FBE-5264D2C060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07DDB0-B91B-43F2-9941-A922926F7B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0AFC3-FC94-49FF-84D9-15B48F7F3FF7}" type="datetimeFigureOut">
              <a:rPr lang="zh-CN" altLang="en-US" smtClean="0"/>
              <a:t>2024/10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516BA5-AB63-A704-D27D-34B505BFFE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9626EC-ECD6-8D48-E814-C75F61F817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E05DEF-445C-42D8-9B95-52FA160C05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6617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31450A-C3B8-AF3E-4DDC-2819FDED6F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8982" y="1122363"/>
            <a:ext cx="9809018" cy="2387600"/>
          </a:xfrm>
        </p:spPr>
        <p:txBody>
          <a:bodyPr/>
          <a:lstStyle/>
          <a:p>
            <a:r>
              <a:rPr lang="en-US" altLang="zh-CN" dirty="0"/>
              <a:t>Raw data time series plots</a:t>
            </a:r>
            <a:endParaRPr lang="zh-CN" altLang="en-US" dirty="0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EF1AED5-7A48-9767-B0EC-C7207D72D68E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altLang="zh-CN" dirty="0"/>
              <a:t>timepoint :360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219294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6D220F-F6AF-8D4F-9E8C-7794282E3F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22791" y="18255"/>
            <a:ext cx="10515600" cy="1325563"/>
          </a:xfrm>
        </p:spPr>
        <p:txBody>
          <a:bodyPr/>
          <a:lstStyle/>
          <a:p>
            <a:r>
              <a:rPr lang="en-US" altLang="zh-CN" dirty="0"/>
              <a:t>Methods</a:t>
            </a:r>
            <a:endParaRPr lang="zh-CN" altLang="en-US" dirty="0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5E6FB37-462D-9A75-BA71-8D7C7BDE47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003177"/>
            <a:ext cx="10515600" cy="5173786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zh-CN" sz="2000" dirty="0"/>
              <a:t>1) Find the original spatial coordinates of the different brain regions</a:t>
            </a:r>
          </a:p>
          <a:p>
            <a:pPr lvl="1"/>
            <a:r>
              <a:rPr lang="en-US" altLang="zh-CN" sz="1600" dirty="0"/>
              <a:t>Obtain the original spatial coordinates of </a:t>
            </a:r>
            <a:r>
              <a:rPr lang="en-US" altLang="zh-CN" sz="1600" dirty="0" err="1"/>
              <a:t>putanmen_L</a:t>
            </a:r>
            <a:r>
              <a:rPr lang="en-US" altLang="zh-CN" sz="1600" dirty="0"/>
              <a:t> (coordinates -21,12,-6) differential brain region in cp_sub_001 subjects -- (-14,4,2)</a:t>
            </a:r>
          </a:p>
          <a:p>
            <a:pPr lvl="1"/>
            <a:r>
              <a:rPr lang="en-US" altLang="zh-CN" sz="1600" dirty="0"/>
              <a:t>Obtain the original spatial coordinates of </a:t>
            </a:r>
            <a:r>
              <a:rPr lang="en-US" altLang="zh-CN" sz="1600" dirty="0" err="1"/>
              <a:t>putanmen_L</a:t>
            </a:r>
            <a:r>
              <a:rPr lang="en-US" altLang="zh-CN" sz="1600" dirty="0"/>
              <a:t> (coordinates -21,12,-6) differential brain region in np_sub_008 subjects -- (-23,12,-4)</a:t>
            </a:r>
          </a:p>
          <a:p>
            <a:pPr lvl="1"/>
            <a:r>
              <a:rPr lang="en-US" altLang="zh-CN" sz="1600" dirty="0"/>
              <a:t>Obtain the original </a:t>
            </a:r>
            <a:r>
              <a:rPr lang="en-US" altLang="zh-CN" sz="1600"/>
              <a:t>spatial </a:t>
            </a:r>
            <a:r>
              <a:rPr lang="en-US" altLang="zh-CN" sz="1600" dirty="0"/>
              <a:t>coordinates</a:t>
            </a:r>
            <a:r>
              <a:rPr lang="en-US" altLang="zh-CN" sz="1600"/>
              <a:t> </a:t>
            </a:r>
            <a:r>
              <a:rPr lang="en-US" altLang="zh-CN" sz="1600" dirty="0"/>
              <a:t>of </a:t>
            </a:r>
            <a:r>
              <a:rPr lang="en-US" altLang="zh-CN" sz="1600" dirty="0" err="1"/>
              <a:t>putanmen_L</a:t>
            </a:r>
            <a:r>
              <a:rPr lang="en-US" altLang="zh-CN" sz="1600" dirty="0"/>
              <a:t> (coordinates -21,12,-6) differential brain region in hc_sub_004 subjects -- (-21,16,-6)</a:t>
            </a:r>
          </a:p>
          <a:p>
            <a:pPr marL="0" indent="0">
              <a:buNone/>
            </a:pPr>
            <a:r>
              <a:rPr lang="en-US" altLang="zh-CN" sz="2000" dirty="0"/>
              <a:t>2) Extract the time series of the original data</a:t>
            </a:r>
          </a:p>
          <a:p>
            <a:pPr lvl="1"/>
            <a:r>
              <a:rPr lang="en-US" altLang="zh-CN" sz="1600" dirty="0"/>
              <a:t>The signal values (360 time points) of the original data time series of cp_sub_001 were extracted with the original spatial coordinates (-14,4,2), and the time series diagram was drawn</a:t>
            </a:r>
          </a:p>
          <a:p>
            <a:pPr lvl="1"/>
            <a:r>
              <a:rPr lang="en-US" altLang="zh-CN" sz="1600" dirty="0"/>
              <a:t>The signal values (360 time points) of the original data time series of np_sub_008 were extracted with the original spatial coordinates (-23,12,-4), and the time series diagram was drawn</a:t>
            </a:r>
          </a:p>
          <a:p>
            <a:pPr lvl="1"/>
            <a:r>
              <a:rPr lang="en-US" altLang="zh-CN" sz="1600" dirty="0"/>
              <a:t>The signal values (360 time points) of the original data time series of hc_sub_004 are extracted with the original spatial coordinates (-21,16,-6), and the time series diagram is drawn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3864024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8FFF7868-341E-CAB3-8BDC-A01761980C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3113123"/>
              </p:ext>
            </p:extLst>
          </p:nvPr>
        </p:nvGraphicFramePr>
        <p:xfrm>
          <a:off x="2464593" y="1866900"/>
          <a:ext cx="7262813" cy="3124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614753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F5A81635-40D7-5FB8-F467-F2E50B4B1AD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3612462"/>
              </p:ext>
            </p:extLst>
          </p:nvPr>
        </p:nvGraphicFramePr>
        <p:xfrm>
          <a:off x="2433637" y="1962149"/>
          <a:ext cx="7324725" cy="29337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2178101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3FD20279-A032-46F9-F4BC-19114DDCA8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1852195"/>
              </p:ext>
            </p:extLst>
          </p:nvPr>
        </p:nvGraphicFramePr>
        <p:xfrm>
          <a:off x="2486025" y="1971675"/>
          <a:ext cx="7219950" cy="2914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216924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91</Words>
  <Application>Microsoft Office PowerPoint</Application>
  <PresentationFormat>宽屏</PresentationFormat>
  <Paragraphs>20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等线 Light</vt:lpstr>
      <vt:lpstr>Arial</vt:lpstr>
      <vt:lpstr>Times New Roman</vt:lpstr>
      <vt:lpstr>Office 主题​​</vt:lpstr>
      <vt:lpstr>Raw data time series plots</vt:lpstr>
      <vt:lpstr>Methods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hkj_020</dc:creator>
  <cp:lastModifiedBy>hy song</cp:lastModifiedBy>
  <cp:revision>6</cp:revision>
  <dcterms:created xsi:type="dcterms:W3CDTF">2024-09-21T01:16:10Z</dcterms:created>
  <dcterms:modified xsi:type="dcterms:W3CDTF">2024-10-07T22:57:07Z</dcterms:modified>
</cp:coreProperties>
</file>